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6" r:id="rId2"/>
    <p:sldId id="257" r:id="rId3"/>
    <p:sldId id="258" r:id="rId4"/>
    <p:sldId id="259" r:id="rId5"/>
    <p:sldId id="261" r:id="rId6"/>
    <p:sldId id="260" r:id="rId7"/>
  </p:sldIdLst>
  <p:sldSz cx="9144000" cy="6858000" type="screen4x3"/>
  <p:notesSz cx="6797675" cy="98726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Yumeng Mao" initials="YM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103" autoAdjust="0"/>
  </p:normalViewPr>
  <p:slideViewPr>
    <p:cSldViewPr>
      <p:cViewPr>
        <p:scale>
          <a:sx n="80" d="100"/>
          <a:sy n="80" d="100"/>
        </p:scale>
        <p:origin x="-864" y="-6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21.emf"/><Relationship Id="rId3" Type="http://schemas.openxmlformats.org/officeDocument/2006/relationships/image" Target="../media/image16.emf"/><Relationship Id="rId7" Type="http://schemas.openxmlformats.org/officeDocument/2006/relationships/image" Target="../media/image20.emf"/><Relationship Id="rId2" Type="http://schemas.openxmlformats.org/officeDocument/2006/relationships/image" Target="../media/image15.emf"/><Relationship Id="rId1" Type="http://schemas.openxmlformats.org/officeDocument/2006/relationships/image" Target="../media/image14.emf"/><Relationship Id="rId6" Type="http://schemas.openxmlformats.org/officeDocument/2006/relationships/image" Target="../media/image19.emf"/><Relationship Id="rId5" Type="http://schemas.openxmlformats.org/officeDocument/2006/relationships/image" Target="../media/image18.emf"/><Relationship Id="rId4" Type="http://schemas.openxmlformats.org/officeDocument/2006/relationships/image" Target="../media/image17.emf"/><Relationship Id="rId9" Type="http://schemas.openxmlformats.org/officeDocument/2006/relationships/image" Target="../media/image2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23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30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42.emf"/><Relationship Id="rId2" Type="http://schemas.openxmlformats.org/officeDocument/2006/relationships/image" Target="../media/image41.emf"/><Relationship Id="rId1" Type="http://schemas.openxmlformats.org/officeDocument/2006/relationships/image" Target="../media/image40.emf"/><Relationship Id="rId4" Type="http://schemas.openxmlformats.org/officeDocument/2006/relationships/image" Target="../media/image43.emf"/></Relationships>
</file>

<file path=ppt/drawings/_rels/vmlDrawing6.vml.rels><?xml version="1.0" encoding="UTF-8" standalone="yes"?>
<Relationships xmlns="http://schemas.openxmlformats.org/package/2006/relationships"><Relationship Id="rId8" Type="http://schemas.openxmlformats.org/officeDocument/2006/relationships/image" Target="../media/image55.emf"/><Relationship Id="rId3" Type="http://schemas.openxmlformats.org/officeDocument/2006/relationships/image" Target="../media/image50.emf"/><Relationship Id="rId7" Type="http://schemas.openxmlformats.org/officeDocument/2006/relationships/image" Target="../media/image54.emf"/><Relationship Id="rId2" Type="http://schemas.openxmlformats.org/officeDocument/2006/relationships/image" Target="../media/image49.emf"/><Relationship Id="rId1" Type="http://schemas.openxmlformats.org/officeDocument/2006/relationships/image" Target="../media/image48.emf"/><Relationship Id="rId6" Type="http://schemas.openxmlformats.org/officeDocument/2006/relationships/image" Target="../media/image53.emf"/><Relationship Id="rId5" Type="http://schemas.openxmlformats.org/officeDocument/2006/relationships/image" Target="../media/image52.emf"/><Relationship Id="rId4" Type="http://schemas.openxmlformats.org/officeDocument/2006/relationships/image" Target="../media/image5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5659" cy="493633"/>
          </a:xfrm>
          <a:prstGeom prst="rect">
            <a:avLst/>
          </a:prstGeom>
        </p:spPr>
        <p:txBody>
          <a:bodyPr vert="horz" lIns="95254" tIns="47627" rIns="95254" bIns="47627" rtlCol="0"/>
          <a:lstStyle>
            <a:lvl1pPr algn="l">
              <a:defRPr sz="1300"/>
            </a:lvl1pPr>
          </a:lstStyle>
          <a:p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1"/>
            <a:ext cx="2945659" cy="493633"/>
          </a:xfrm>
          <a:prstGeom prst="rect">
            <a:avLst/>
          </a:prstGeom>
        </p:spPr>
        <p:txBody>
          <a:bodyPr vert="horz" lIns="95254" tIns="47627" rIns="95254" bIns="47627" rtlCol="0"/>
          <a:lstStyle>
            <a:lvl1pPr algn="r">
              <a:defRPr sz="1300"/>
            </a:lvl1pPr>
          </a:lstStyle>
          <a:p>
            <a:fld id="{54851A76-27A5-4E3A-AD75-4AEAAE96C70D}" type="datetimeFigureOut">
              <a:rPr lang="sv-SE" smtClean="0"/>
              <a:t>2016-07-10</a:t>
            </a:fld>
            <a:endParaRPr lang="sv-S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31863" y="741363"/>
            <a:ext cx="4933950" cy="37004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254" tIns="47627" rIns="95254" bIns="47627" rtlCol="0" anchor="ctr"/>
          <a:lstStyle/>
          <a:p>
            <a:endParaRPr lang="sv-S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689515"/>
            <a:ext cx="5438140" cy="4442698"/>
          </a:xfrm>
          <a:prstGeom prst="rect">
            <a:avLst/>
          </a:prstGeom>
        </p:spPr>
        <p:txBody>
          <a:bodyPr vert="horz" lIns="95254" tIns="47627" rIns="95254" bIns="47627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7317"/>
            <a:ext cx="2945659" cy="493633"/>
          </a:xfrm>
          <a:prstGeom prst="rect">
            <a:avLst/>
          </a:prstGeom>
        </p:spPr>
        <p:txBody>
          <a:bodyPr vert="horz" lIns="95254" tIns="47627" rIns="95254" bIns="47627" rtlCol="0" anchor="b"/>
          <a:lstStyle>
            <a:lvl1pPr algn="l">
              <a:defRPr sz="1300"/>
            </a:lvl1pPr>
          </a:lstStyle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7317"/>
            <a:ext cx="2945659" cy="493633"/>
          </a:xfrm>
          <a:prstGeom prst="rect">
            <a:avLst/>
          </a:prstGeom>
        </p:spPr>
        <p:txBody>
          <a:bodyPr vert="horz" lIns="95254" tIns="47627" rIns="95254" bIns="47627" rtlCol="0" anchor="b"/>
          <a:lstStyle>
            <a:lvl1pPr algn="r">
              <a:defRPr sz="1300"/>
            </a:lvl1pPr>
          </a:lstStyle>
          <a:p>
            <a:fld id="{E4B3D8AD-EEAD-4FF0-868E-286D0BF4D61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272765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B3D8AD-EEAD-4FF0-868E-286D0BF4D615}" type="slidenum">
              <a:rPr lang="sv-SE" smtClean="0"/>
              <a:t>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936478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18" Type="http://schemas.openxmlformats.org/officeDocument/2006/relationships/oleObject" Target="../embeddings/oleObject8.bin"/><Relationship Id="rId26" Type="http://schemas.openxmlformats.org/officeDocument/2006/relationships/oleObject" Target="../embeddings/oleObject12.bin"/><Relationship Id="rId3" Type="http://schemas.openxmlformats.org/officeDocument/2006/relationships/notesSlide" Target="../notesSlides/notesSlide1.xml"/><Relationship Id="rId21" Type="http://schemas.openxmlformats.org/officeDocument/2006/relationships/image" Target="../media/image9.emf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7.emf"/><Relationship Id="rId25" Type="http://schemas.openxmlformats.org/officeDocument/2006/relationships/image" Target="../media/image11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7.bin"/><Relationship Id="rId20" Type="http://schemas.openxmlformats.org/officeDocument/2006/relationships/oleObject" Target="../embeddings/oleObject9.bin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24" Type="http://schemas.openxmlformats.org/officeDocument/2006/relationships/oleObject" Target="../embeddings/oleObject11.bin"/><Relationship Id="rId5" Type="http://schemas.openxmlformats.org/officeDocument/2006/relationships/image" Target="../media/image1.emf"/><Relationship Id="rId15" Type="http://schemas.openxmlformats.org/officeDocument/2006/relationships/image" Target="../media/image6.emf"/><Relationship Id="rId23" Type="http://schemas.openxmlformats.org/officeDocument/2006/relationships/image" Target="../media/image10.emf"/><Relationship Id="rId28" Type="http://schemas.openxmlformats.org/officeDocument/2006/relationships/image" Target="../media/image13.png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8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oleObject" Target="../embeddings/oleObject6.bin"/><Relationship Id="rId22" Type="http://schemas.openxmlformats.org/officeDocument/2006/relationships/oleObject" Target="../embeddings/oleObject10.bin"/><Relationship Id="rId27" Type="http://schemas.openxmlformats.org/officeDocument/2006/relationships/image" Target="../media/image12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13" Type="http://schemas.openxmlformats.org/officeDocument/2006/relationships/oleObject" Target="../embeddings/oleObject18.bin"/><Relationship Id="rId18" Type="http://schemas.openxmlformats.org/officeDocument/2006/relationships/image" Target="../media/image21.emf"/><Relationship Id="rId3" Type="http://schemas.openxmlformats.org/officeDocument/2006/relationships/oleObject" Target="../embeddings/oleObject13.bin"/><Relationship Id="rId7" Type="http://schemas.openxmlformats.org/officeDocument/2006/relationships/oleObject" Target="../embeddings/oleObject15.bin"/><Relationship Id="rId12" Type="http://schemas.openxmlformats.org/officeDocument/2006/relationships/image" Target="../media/image18.emf"/><Relationship Id="rId17" Type="http://schemas.openxmlformats.org/officeDocument/2006/relationships/oleObject" Target="../embeddings/oleObject20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20.emf"/><Relationship Id="rId20" Type="http://schemas.openxmlformats.org/officeDocument/2006/relationships/image" Target="../media/image22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15.emf"/><Relationship Id="rId11" Type="http://schemas.openxmlformats.org/officeDocument/2006/relationships/oleObject" Target="../embeddings/oleObject17.bin"/><Relationship Id="rId5" Type="http://schemas.openxmlformats.org/officeDocument/2006/relationships/oleObject" Target="../embeddings/oleObject14.bin"/><Relationship Id="rId15" Type="http://schemas.openxmlformats.org/officeDocument/2006/relationships/oleObject" Target="../embeddings/oleObject19.bin"/><Relationship Id="rId10" Type="http://schemas.openxmlformats.org/officeDocument/2006/relationships/image" Target="../media/image17.emf"/><Relationship Id="rId19" Type="http://schemas.openxmlformats.org/officeDocument/2006/relationships/oleObject" Target="../embeddings/oleObject21.bin"/><Relationship Id="rId4" Type="http://schemas.openxmlformats.org/officeDocument/2006/relationships/image" Target="../media/image14.emf"/><Relationship Id="rId9" Type="http://schemas.openxmlformats.org/officeDocument/2006/relationships/oleObject" Target="../embeddings/oleObject16.bin"/><Relationship Id="rId14" Type="http://schemas.openxmlformats.org/officeDocument/2006/relationships/image" Target="../media/image19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3" Type="http://schemas.openxmlformats.org/officeDocument/2006/relationships/image" Target="../media/image24.jpeg"/><Relationship Id="rId7" Type="http://schemas.openxmlformats.org/officeDocument/2006/relationships/image" Target="../media/image23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22.bin"/><Relationship Id="rId5" Type="http://schemas.openxmlformats.org/officeDocument/2006/relationships/image" Target="../media/image26.png"/><Relationship Id="rId10" Type="http://schemas.openxmlformats.org/officeDocument/2006/relationships/image" Target="../media/image29.png"/><Relationship Id="rId4" Type="http://schemas.openxmlformats.org/officeDocument/2006/relationships/image" Target="../media/image25.png"/><Relationship Id="rId9" Type="http://schemas.openxmlformats.org/officeDocument/2006/relationships/image" Target="../media/image2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13" Type="http://schemas.openxmlformats.org/officeDocument/2006/relationships/image" Target="../media/image39.png"/><Relationship Id="rId3" Type="http://schemas.openxmlformats.org/officeDocument/2006/relationships/oleObject" Target="../embeddings/oleObject23.bin"/><Relationship Id="rId7" Type="http://schemas.openxmlformats.org/officeDocument/2006/relationships/image" Target="../media/image33.png"/><Relationship Id="rId12" Type="http://schemas.openxmlformats.org/officeDocument/2006/relationships/image" Target="../media/image38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32.png"/><Relationship Id="rId11" Type="http://schemas.openxmlformats.org/officeDocument/2006/relationships/image" Target="../media/image37.png"/><Relationship Id="rId5" Type="http://schemas.openxmlformats.org/officeDocument/2006/relationships/image" Target="../media/image31.png"/><Relationship Id="rId10" Type="http://schemas.openxmlformats.org/officeDocument/2006/relationships/image" Target="../media/image36.png"/><Relationship Id="rId4" Type="http://schemas.openxmlformats.org/officeDocument/2006/relationships/image" Target="../media/image30.emf"/><Relationship Id="rId9" Type="http://schemas.openxmlformats.org/officeDocument/2006/relationships/image" Target="../media/image3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emf"/><Relationship Id="rId13" Type="http://schemas.openxmlformats.org/officeDocument/2006/relationships/image" Target="../media/image46.emf"/><Relationship Id="rId3" Type="http://schemas.openxmlformats.org/officeDocument/2006/relationships/oleObject" Target="../embeddings/oleObject24.bin"/><Relationship Id="rId7" Type="http://schemas.openxmlformats.org/officeDocument/2006/relationships/oleObject" Target="../embeddings/oleObject25.bin"/><Relationship Id="rId12" Type="http://schemas.openxmlformats.org/officeDocument/2006/relationships/image" Target="../media/image43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45.png"/><Relationship Id="rId11" Type="http://schemas.openxmlformats.org/officeDocument/2006/relationships/oleObject" Target="../embeddings/oleObject27.bin"/><Relationship Id="rId5" Type="http://schemas.openxmlformats.org/officeDocument/2006/relationships/image" Target="../media/image44.png"/><Relationship Id="rId10" Type="http://schemas.openxmlformats.org/officeDocument/2006/relationships/image" Target="../media/image42.emf"/><Relationship Id="rId4" Type="http://schemas.openxmlformats.org/officeDocument/2006/relationships/image" Target="../media/image40.emf"/><Relationship Id="rId9" Type="http://schemas.openxmlformats.org/officeDocument/2006/relationships/oleObject" Target="../embeddings/oleObject26.bin"/><Relationship Id="rId14" Type="http://schemas.openxmlformats.org/officeDocument/2006/relationships/image" Target="../media/image47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emf"/><Relationship Id="rId13" Type="http://schemas.openxmlformats.org/officeDocument/2006/relationships/image" Target="../media/image56.emf"/><Relationship Id="rId18" Type="http://schemas.openxmlformats.org/officeDocument/2006/relationships/oleObject" Target="../embeddings/oleObject35.bin"/><Relationship Id="rId3" Type="http://schemas.openxmlformats.org/officeDocument/2006/relationships/oleObject" Target="../embeddings/oleObject28.bin"/><Relationship Id="rId7" Type="http://schemas.openxmlformats.org/officeDocument/2006/relationships/oleObject" Target="../embeddings/oleObject30.bin"/><Relationship Id="rId12" Type="http://schemas.openxmlformats.org/officeDocument/2006/relationships/image" Target="../media/image52.emf"/><Relationship Id="rId17" Type="http://schemas.openxmlformats.org/officeDocument/2006/relationships/image" Target="../media/image54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34.bin"/><Relationship Id="rId1" Type="http://schemas.openxmlformats.org/officeDocument/2006/relationships/vmlDrawing" Target="../drawings/vmlDrawing6.vml"/><Relationship Id="rId6" Type="http://schemas.openxmlformats.org/officeDocument/2006/relationships/image" Target="../media/image49.emf"/><Relationship Id="rId11" Type="http://schemas.openxmlformats.org/officeDocument/2006/relationships/oleObject" Target="../embeddings/oleObject32.bin"/><Relationship Id="rId5" Type="http://schemas.openxmlformats.org/officeDocument/2006/relationships/oleObject" Target="../embeddings/oleObject29.bin"/><Relationship Id="rId15" Type="http://schemas.openxmlformats.org/officeDocument/2006/relationships/image" Target="../media/image53.emf"/><Relationship Id="rId10" Type="http://schemas.openxmlformats.org/officeDocument/2006/relationships/image" Target="../media/image51.emf"/><Relationship Id="rId19" Type="http://schemas.openxmlformats.org/officeDocument/2006/relationships/image" Target="../media/image55.emf"/><Relationship Id="rId4" Type="http://schemas.openxmlformats.org/officeDocument/2006/relationships/image" Target="../media/image48.emf"/><Relationship Id="rId9" Type="http://schemas.openxmlformats.org/officeDocument/2006/relationships/oleObject" Target="../embeddings/oleObject31.bin"/><Relationship Id="rId14" Type="http://schemas.openxmlformats.org/officeDocument/2006/relationships/oleObject" Target="../embeddings/oleObject33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/>
          <p:cNvSpPr txBox="1"/>
          <p:nvPr/>
        </p:nvSpPr>
        <p:spPr>
          <a:xfrm>
            <a:off x="3500300" y="37573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sv-S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8028" y="33265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sv-S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0" y="0"/>
            <a:ext cx="799610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  <a:r>
              <a:rPr lang="sv-S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Immune subsets important for anti-tumor activity of combination treatment.</a:t>
            </a:r>
            <a:endParaRPr lang="sv-S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sv-S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sv-S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429174" y="2717880"/>
            <a:ext cx="4836239" cy="2117118"/>
            <a:chOff x="2844905" y="385192"/>
            <a:chExt cx="4836239" cy="2117118"/>
          </a:xfrm>
        </p:grpSpPr>
        <p:grpSp>
          <p:nvGrpSpPr>
            <p:cNvPr id="16" name="Group 15"/>
            <p:cNvGrpSpPr/>
            <p:nvPr/>
          </p:nvGrpSpPr>
          <p:grpSpPr>
            <a:xfrm>
              <a:off x="2875782" y="385192"/>
              <a:ext cx="4805362" cy="2117118"/>
              <a:chOff x="1698523" y="537304"/>
              <a:chExt cx="4805362" cy="2117118"/>
            </a:xfrm>
          </p:grpSpPr>
          <p:graphicFrame>
            <p:nvGraphicFramePr>
              <p:cNvPr id="18" name="Object 17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7302467"/>
                  </p:ext>
                </p:extLst>
              </p:nvPr>
            </p:nvGraphicFramePr>
            <p:xfrm>
              <a:off x="3392385" y="927222"/>
              <a:ext cx="1671638" cy="16986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8546" name="Prism 6" r:id="rId4" imgW="2384697" imgH="2410663" progId="Prism6.Document">
                      <p:embed/>
                    </p:oleObj>
                  </mc:Choice>
                  <mc:Fallback>
                    <p:oleObj name="Prism 6" r:id="rId4" imgW="2384697" imgH="2410663" progId="Prism6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3392385" y="927222"/>
                            <a:ext cx="1671638" cy="16986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9" name="Object 18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156721495"/>
                  </p:ext>
                </p:extLst>
              </p:nvPr>
            </p:nvGraphicFramePr>
            <p:xfrm>
              <a:off x="4830660" y="927222"/>
              <a:ext cx="1673225" cy="171291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8547" name="Prism 6" r:id="rId6" imgW="2387937" imgH="2450259" progId="Prism6.Document">
                      <p:embed/>
                    </p:oleObj>
                  </mc:Choice>
                  <mc:Fallback>
                    <p:oleObj name="Prism 6" r:id="rId6" imgW="2387937" imgH="2450259" progId="Prism6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4830660" y="927222"/>
                            <a:ext cx="1673225" cy="171291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0" name="Object 19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878089270"/>
                  </p:ext>
                </p:extLst>
              </p:nvPr>
            </p:nvGraphicFramePr>
            <p:xfrm>
              <a:off x="1698523" y="781172"/>
              <a:ext cx="1944687" cy="18732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8548" name="Prism 6" r:id="rId8" imgW="2695698" imgH="2599643" progId="Prism6.Document">
                      <p:embed/>
                    </p:oleObj>
                  </mc:Choice>
                  <mc:Fallback>
                    <p:oleObj name="Prism 6" r:id="rId8" imgW="2695698" imgH="2599643" progId="Prism6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1698523" y="781172"/>
                            <a:ext cx="1944687" cy="18732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1" name="TextBox 20"/>
              <p:cNvSpPr txBox="1"/>
              <p:nvPr/>
            </p:nvSpPr>
            <p:spPr>
              <a:xfrm>
                <a:off x="2275981" y="537304"/>
                <a:ext cx="99257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acrophages </a:t>
                </a:r>
              </a:p>
              <a:p>
                <a:pPr algn="ctr"/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4/80+</a:t>
                </a:r>
                <a:endParaRPr lang="sv-SE" sz="1000" dirty="0">
                  <a:latin typeface="Symbol" panose="05050102010706020507" pitchFamily="18" charset="2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3793179" y="537304"/>
                <a:ext cx="93487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rMDSC</a:t>
                </a:r>
              </a:p>
              <a:p>
                <a:pPr algn="ctr"/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y6g+Ly6c</a:t>
                </a:r>
                <a:r>
                  <a:rPr lang="sv-SE" sz="1000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ow</a:t>
                </a:r>
                <a:endParaRPr lang="sv-SE" sz="10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5315851" y="537304"/>
                <a:ext cx="84830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oMDSC</a:t>
                </a:r>
              </a:p>
              <a:p>
                <a:pPr algn="ctr"/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y6g-Ly6c+</a:t>
                </a:r>
                <a:endParaRPr lang="sv-S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5" name="TextBox 54"/>
            <p:cNvSpPr txBox="1"/>
            <p:nvPr/>
          </p:nvSpPr>
          <p:spPr>
            <a:xfrm>
              <a:off x="2844905" y="392891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leen</a:t>
              </a:r>
              <a:endParaRPr lang="sv-SE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5299044" y="2717880"/>
            <a:ext cx="3640106" cy="2124217"/>
            <a:chOff x="2859368" y="3169509"/>
            <a:chExt cx="3640106" cy="2124217"/>
          </a:xfrm>
        </p:grpSpPr>
        <p:grpSp>
          <p:nvGrpSpPr>
            <p:cNvPr id="39" name="Group 38"/>
            <p:cNvGrpSpPr/>
            <p:nvPr/>
          </p:nvGrpSpPr>
          <p:grpSpPr>
            <a:xfrm>
              <a:off x="3126036" y="3472864"/>
              <a:ext cx="3373438" cy="1820862"/>
              <a:chOff x="1897834" y="3324216"/>
              <a:chExt cx="3373438" cy="1820862"/>
            </a:xfrm>
          </p:grpSpPr>
          <p:graphicFrame>
            <p:nvGraphicFramePr>
              <p:cNvPr id="26" name="Object 25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031218252"/>
                  </p:ext>
                </p:extLst>
              </p:nvPr>
            </p:nvGraphicFramePr>
            <p:xfrm>
              <a:off x="1897834" y="3367449"/>
              <a:ext cx="1820863" cy="17748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8549" name="Prism 6" r:id="rId10" imgW="2509601" imgH="2442700" progId="Prism6.Document">
                      <p:embed/>
                    </p:oleObj>
                  </mc:Choice>
                  <mc:Fallback>
                    <p:oleObj name="Prism 6" r:id="rId10" imgW="2509601" imgH="2442700" progId="Prism6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1897834" y="3367449"/>
                            <a:ext cx="1820863" cy="17748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7" name="Object 2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987223674"/>
                  </p:ext>
                </p:extLst>
              </p:nvPr>
            </p:nvGraphicFramePr>
            <p:xfrm>
              <a:off x="3383735" y="3324216"/>
              <a:ext cx="1887537" cy="18208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8550" name="Prism 6" r:id="rId12" imgW="2503482" imgH="2416782" progId="Prism6.Document">
                      <p:embed/>
                    </p:oleObj>
                  </mc:Choice>
                  <mc:Fallback>
                    <p:oleObj name="Prism 6" r:id="rId12" imgW="2503482" imgH="2416782" progId="Prism6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3"/>
                          <a:stretch>
                            <a:fillRect/>
                          </a:stretch>
                        </p:blipFill>
                        <p:spPr>
                          <a:xfrm>
                            <a:off x="3383735" y="3324216"/>
                            <a:ext cx="1887537" cy="18208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40" name="TextBox 39"/>
            <p:cNvSpPr txBox="1"/>
            <p:nvPr/>
          </p:nvSpPr>
          <p:spPr>
            <a:xfrm>
              <a:off x="3438343" y="3169509"/>
              <a:ext cx="134556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0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crophages</a:t>
              </a:r>
            </a:p>
            <a:p>
              <a:pPr algn="ctr"/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15+</a:t>
              </a:r>
              <a:endParaRPr lang="sv-SE" sz="1000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5127874" y="3177532"/>
              <a:ext cx="74090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sv-SE" sz="1000" dirty="0">
                  <a:latin typeface="Arial" panose="020B0604020202020204" pitchFamily="34" charset="0"/>
                  <a:cs typeface="Arial" panose="020B0604020202020204" pitchFamily="34" charset="0"/>
                </a:rPr>
                <a:t>moMDSC</a:t>
              </a:r>
              <a:endParaRPr lang="sv-SE" sz="1000" dirty="0">
                <a:latin typeface="Symbol" panose="05050102010706020507" pitchFamily="18" charset="2"/>
                <a:cs typeface="Arial" panose="020B0604020202020204" pitchFamily="34" charset="0"/>
              </a:endParaRPr>
            </a:p>
            <a:p>
              <a:pPr algn="r"/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15+</a:t>
              </a:r>
              <a:endParaRPr lang="sv-SE" sz="1000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2859368" y="3194829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leen</a:t>
              </a:r>
              <a:endParaRPr lang="sv-SE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0" name="TextBox 69"/>
          <p:cNvSpPr txBox="1"/>
          <p:nvPr/>
        </p:nvSpPr>
        <p:spPr>
          <a:xfrm>
            <a:off x="28028" y="25908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sv-S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" name="Group 37"/>
          <p:cNvGrpSpPr/>
          <p:nvPr/>
        </p:nvGrpSpPr>
        <p:grpSpPr>
          <a:xfrm>
            <a:off x="3729038" y="464127"/>
            <a:ext cx="3424237" cy="2220913"/>
            <a:chOff x="3352800" y="457200"/>
            <a:chExt cx="3424237" cy="2220913"/>
          </a:xfrm>
        </p:grpSpPr>
        <p:graphicFrame>
          <p:nvGraphicFramePr>
            <p:cNvPr id="73" name="Object 7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04508344"/>
                </p:ext>
              </p:extLst>
            </p:nvPr>
          </p:nvGraphicFramePr>
          <p:xfrm>
            <a:off x="4910137" y="805873"/>
            <a:ext cx="1866900" cy="1870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551" name="Prism 6" r:id="rId14" imgW="2694258" imgH="2692513" progId="Prism6.Document">
                    <p:embed/>
                  </p:oleObj>
                </mc:Choice>
                <mc:Fallback>
                  <p:oleObj name="Prism 6" r:id="rId14" imgW="2694258" imgH="2692513" progId="Prism6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910137" y="805873"/>
                          <a:ext cx="1866900" cy="187007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4" name="Object 7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32006734"/>
                </p:ext>
              </p:extLst>
            </p:nvPr>
          </p:nvGraphicFramePr>
          <p:xfrm>
            <a:off x="3352800" y="847725"/>
            <a:ext cx="1733550" cy="18303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552" name="Prism 6" r:id="rId16" imgW="2418173" imgH="2551048" progId="Prism6.Document">
                    <p:embed/>
                  </p:oleObj>
                </mc:Choice>
                <mc:Fallback>
                  <p:oleObj name="Prism 6" r:id="rId16" imgW="2418173" imgH="2551048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3352800" y="847725"/>
                          <a:ext cx="1733550" cy="18303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5" name="TextBox 74"/>
            <p:cNvSpPr txBox="1"/>
            <p:nvPr/>
          </p:nvSpPr>
          <p:spPr>
            <a:xfrm>
              <a:off x="3832395" y="457200"/>
              <a:ext cx="8467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4 T cells</a:t>
              </a:r>
            </a:p>
            <a:p>
              <a:pPr algn="ctr"/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spleen)</a:t>
              </a:r>
              <a:endParaRPr lang="sv-S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5356395" y="457200"/>
              <a:ext cx="8467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4 T cells</a:t>
              </a:r>
            </a:p>
            <a:p>
              <a:pPr algn="ctr"/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tumor)</a:t>
              </a:r>
              <a:endParaRPr lang="sv-S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5347776" y="4818406"/>
            <a:ext cx="3720024" cy="2076101"/>
            <a:chOff x="5476426" y="5123206"/>
            <a:chExt cx="3720024" cy="2076101"/>
          </a:xfrm>
        </p:grpSpPr>
        <p:graphicFrame>
          <p:nvGraphicFramePr>
            <p:cNvPr id="71" name="Object 7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48773120"/>
                </p:ext>
              </p:extLst>
            </p:nvPr>
          </p:nvGraphicFramePr>
          <p:xfrm>
            <a:off x="5954579" y="5521702"/>
            <a:ext cx="1724292" cy="167760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553" name="Prism 6" r:id="rId18" imgW="2505282" imgH="2433700" progId="Prism6.Document">
                    <p:embed/>
                  </p:oleObj>
                </mc:Choice>
                <mc:Fallback>
                  <p:oleObj name="Prism 6" r:id="rId18" imgW="2505282" imgH="2433700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5954579" y="5521702"/>
                          <a:ext cx="1724292" cy="167760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2" name="Object 7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25159348"/>
                </p:ext>
              </p:extLst>
            </p:nvPr>
          </p:nvGraphicFramePr>
          <p:xfrm>
            <a:off x="7512112" y="5444384"/>
            <a:ext cx="1684338" cy="17367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554" name="Prism 6" r:id="rId20" imgW="2503482" imgH="2593523" progId="Prism6.Document">
                    <p:embed/>
                  </p:oleObj>
                </mc:Choice>
                <mc:Fallback>
                  <p:oleObj name="Prism 6" r:id="rId20" imgW="2503482" imgH="2593523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1"/>
                        <a:stretch>
                          <a:fillRect/>
                        </a:stretch>
                      </p:blipFill>
                      <p:spPr>
                        <a:xfrm>
                          <a:off x="7512112" y="5444384"/>
                          <a:ext cx="1684338" cy="17367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8" name="TextBox 67"/>
            <p:cNvSpPr txBox="1"/>
            <p:nvPr/>
          </p:nvSpPr>
          <p:spPr>
            <a:xfrm>
              <a:off x="6324600" y="5126835"/>
              <a:ext cx="95731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acrophages</a:t>
              </a:r>
            </a:p>
            <a:p>
              <a:pPr algn="ctr"/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15+</a:t>
              </a:r>
              <a:endParaRPr lang="sv-SE" sz="1000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7924800" y="5126835"/>
              <a:ext cx="7505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MDSC</a:t>
              </a:r>
            </a:p>
            <a:p>
              <a:pPr algn="ctr"/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15+</a:t>
              </a:r>
              <a:endParaRPr lang="sv-SE" sz="1000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5476426" y="5123206"/>
              <a:ext cx="5485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endParaRPr lang="sv-SE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429174" y="4800600"/>
            <a:ext cx="4981026" cy="2116508"/>
            <a:chOff x="271330" y="4800600"/>
            <a:chExt cx="4981026" cy="2116508"/>
          </a:xfrm>
        </p:grpSpPr>
        <p:graphicFrame>
          <p:nvGraphicFramePr>
            <p:cNvPr id="63" name="Object 6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96740308"/>
                </p:ext>
              </p:extLst>
            </p:nvPr>
          </p:nvGraphicFramePr>
          <p:xfrm>
            <a:off x="350580" y="5067690"/>
            <a:ext cx="1855350" cy="182804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555" name="Prism 6" r:id="rId22" imgW="2686339" imgH="2645358" progId="Prism6.Document">
                    <p:embed/>
                  </p:oleObj>
                </mc:Choice>
                <mc:Fallback>
                  <p:oleObj name="Prism 6" r:id="rId22" imgW="2686339" imgH="2645358" progId="Prism6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23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50580" y="5067690"/>
                          <a:ext cx="1855350" cy="182804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4" name="Object 6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38856927"/>
                </p:ext>
              </p:extLst>
            </p:nvPr>
          </p:nvGraphicFramePr>
          <p:xfrm>
            <a:off x="2143253" y="5100559"/>
            <a:ext cx="1641218" cy="181654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556" name="Prism 6" r:id="rId24" imgW="2380018" imgH="2628800" progId="Prism6.Document">
                    <p:embed/>
                  </p:oleObj>
                </mc:Choice>
                <mc:Fallback>
                  <p:oleObj name="Prism 6" r:id="rId24" imgW="2380018" imgH="2628800" progId="Prism6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2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143253" y="5100559"/>
                          <a:ext cx="1641218" cy="1816549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5" name="Object 6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34731415"/>
                </p:ext>
              </p:extLst>
            </p:nvPr>
          </p:nvGraphicFramePr>
          <p:xfrm>
            <a:off x="3691618" y="5279219"/>
            <a:ext cx="1560738" cy="160097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557" name="Prism 6" r:id="rId26" imgW="2384697" imgH="2441260" progId="Prism6.Document">
                    <p:embed/>
                  </p:oleObj>
                </mc:Choice>
                <mc:Fallback>
                  <p:oleObj name="Prism 6" r:id="rId26" imgW="2384697" imgH="2441260" progId="Prism6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27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691618" y="5279219"/>
                          <a:ext cx="1560738" cy="1600976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9" name="TextBox 58"/>
            <p:cNvSpPr txBox="1"/>
            <p:nvPr/>
          </p:nvSpPr>
          <p:spPr>
            <a:xfrm>
              <a:off x="271330" y="4800600"/>
              <a:ext cx="5485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endParaRPr lang="sv-SE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914400" y="4814960"/>
              <a:ext cx="99257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acrophages </a:t>
              </a:r>
            </a:p>
            <a:p>
              <a:pPr algn="ctr"/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4/80+</a:t>
              </a:r>
              <a:endParaRPr lang="sv-SE" sz="1000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2432025" y="4814960"/>
              <a:ext cx="93487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rMDSC</a:t>
              </a:r>
            </a:p>
            <a:p>
              <a:pPr algn="ctr"/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y6g+Ly6c</a:t>
              </a:r>
              <a:r>
                <a:rPr lang="sv-SE" sz="10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  <a:endParaRPr lang="sv-SE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4034234" y="4814960"/>
              <a:ext cx="84830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MDSC</a:t>
              </a:r>
            </a:p>
            <a:p>
              <a:pPr algn="ctr"/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y6g-Ly6c+</a:t>
              </a:r>
              <a:endParaRPr lang="sv-S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2" name="TextBox 81"/>
          <p:cNvSpPr txBox="1"/>
          <p:nvPr/>
        </p:nvSpPr>
        <p:spPr>
          <a:xfrm>
            <a:off x="5052950" y="25908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sv-S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28028" y="467748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sv-S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5052950" y="4677489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sv-S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403414" y="457200"/>
            <a:ext cx="2691839" cy="2133600"/>
            <a:chOff x="403414" y="457200"/>
            <a:chExt cx="2691839" cy="2133600"/>
          </a:xfrm>
        </p:grpSpPr>
        <p:grpSp>
          <p:nvGrpSpPr>
            <p:cNvPr id="34" name="Group 33"/>
            <p:cNvGrpSpPr/>
            <p:nvPr/>
          </p:nvGrpSpPr>
          <p:grpSpPr>
            <a:xfrm>
              <a:off x="403414" y="457200"/>
              <a:ext cx="2691839" cy="2133600"/>
              <a:chOff x="1162120" y="-328520"/>
              <a:chExt cx="6055123" cy="5393056"/>
            </a:xfrm>
          </p:grpSpPr>
          <p:grpSp>
            <p:nvGrpSpPr>
              <p:cNvPr id="35" name="Group 34"/>
              <p:cNvGrpSpPr/>
              <p:nvPr/>
            </p:nvGrpSpPr>
            <p:grpSpPr>
              <a:xfrm>
                <a:off x="1162120" y="-328520"/>
                <a:ext cx="4195648" cy="5393056"/>
                <a:chOff x="1162120" y="-328520"/>
                <a:chExt cx="4195648" cy="5393056"/>
              </a:xfrm>
            </p:grpSpPr>
            <p:pic>
              <p:nvPicPr>
                <p:cNvPr id="52" name="Picture 4" descr="C:\Users\yummao\AppData\Local\Temp\copypicture.png"/>
                <p:cNvPicPr>
                  <a:picLocks noChangeAspect="1" noChangeArrowheads="1"/>
                </p:cNvPicPr>
                <p:nvPr/>
              </p:nvPicPr>
              <p:blipFill>
                <a:blip r:embed="rId2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162120" y="590832"/>
                  <a:ext cx="4195648" cy="4473704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53" name="TextBox 52"/>
                <p:cNvSpPr txBox="1"/>
                <p:nvPr/>
              </p:nvSpPr>
              <p:spPr>
                <a:xfrm>
                  <a:off x="1283108" y="-328520"/>
                  <a:ext cx="3962409" cy="7529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CA-X </a:t>
                  </a:r>
                </a:p>
                <a:p>
                  <a:pPr algn="ctr"/>
                  <a:r>
                    <a:rPr lang="sv-SE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(immune subsets, n=59)</a:t>
                  </a:r>
                  <a:endParaRPr lang="sv-SE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3" name="Group 42"/>
              <p:cNvGrpSpPr/>
              <p:nvPr/>
            </p:nvGrpSpPr>
            <p:grpSpPr>
              <a:xfrm>
                <a:off x="4855971" y="745464"/>
                <a:ext cx="2083573" cy="544573"/>
                <a:chOff x="4371398" y="745464"/>
                <a:chExt cx="2083573" cy="544573"/>
              </a:xfrm>
            </p:grpSpPr>
            <p:sp>
              <p:nvSpPr>
                <p:cNvPr id="50" name="TextBox 49"/>
                <p:cNvSpPr txBox="1"/>
                <p:nvPr/>
              </p:nvSpPr>
              <p:spPr>
                <a:xfrm>
                  <a:off x="4444572" y="745464"/>
                  <a:ext cx="2010399" cy="54457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umor-bearing</a:t>
                  </a:r>
                  <a:endParaRPr lang="sv-SE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Flowchart: Connector 50"/>
                <p:cNvSpPr/>
                <p:nvPr/>
              </p:nvSpPr>
              <p:spPr>
                <a:xfrm>
                  <a:off x="4371398" y="916980"/>
                  <a:ext cx="161960" cy="180001"/>
                </a:xfrm>
                <a:prstGeom prst="flowChartConnector">
                  <a:avLst/>
                </a:prstGeom>
              </p:spPr>
              <p:style>
                <a:lnRef idx="2">
                  <a:schemeClr val="accent3">
                    <a:shade val="50000"/>
                  </a:schemeClr>
                </a:lnRef>
                <a:fillRef idx="1">
                  <a:schemeClr val="accent3"/>
                </a:fillRef>
                <a:effectRef idx="0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 sz="800"/>
                </a:p>
              </p:txBody>
            </p:sp>
          </p:grpSp>
          <p:grpSp>
            <p:nvGrpSpPr>
              <p:cNvPr id="44" name="Group 43"/>
              <p:cNvGrpSpPr/>
              <p:nvPr/>
            </p:nvGrpSpPr>
            <p:grpSpPr>
              <a:xfrm>
                <a:off x="4855970" y="1290037"/>
                <a:ext cx="1862876" cy="544573"/>
                <a:chOff x="4371397" y="963075"/>
                <a:chExt cx="1862876" cy="544573"/>
              </a:xfrm>
            </p:grpSpPr>
            <p:sp>
              <p:nvSpPr>
                <p:cNvPr id="48" name="TextBox 47"/>
                <p:cNvSpPr txBox="1"/>
                <p:nvPr/>
              </p:nvSpPr>
              <p:spPr>
                <a:xfrm>
                  <a:off x="4444571" y="963075"/>
                  <a:ext cx="1789702" cy="54457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αPD-1</a:t>
                  </a:r>
                  <a:endParaRPr lang="sv-SE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Flowchart: Connector 48"/>
                <p:cNvSpPr/>
                <p:nvPr/>
              </p:nvSpPr>
              <p:spPr>
                <a:xfrm>
                  <a:off x="4371397" y="1134588"/>
                  <a:ext cx="161960" cy="180001"/>
                </a:xfrm>
                <a:prstGeom prst="flowChartConnector">
                  <a:avLst/>
                </a:prstGeom>
                <a:solidFill>
                  <a:srgbClr val="FFFF00"/>
                </a:solidFill>
                <a:ln>
                  <a:solidFill>
                    <a:schemeClr val="bg2">
                      <a:lumMod val="50000"/>
                    </a:schemeClr>
                  </a:solidFill>
                </a:ln>
              </p:spPr>
              <p:style>
                <a:lnRef idx="2">
                  <a:schemeClr val="accent3">
                    <a:shade val="50000"/>
                  </a:schemeClr>
                </a:lnRef>
                <a:fillRef idx="1">
                  <a:schemeClr val="accent3"/>
                </a:fillRef>
                <a:effectRef idx="0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 sz="800" b="1">
                    <a:ln w="12700">
                      <a:solidFill>
                        <a:schemeClr val="tx2">
                          <a:satMod val="155000"/>
                        </a:schemeClr>
                      </a:solidFill>
                      <a:prstDash val="solid"/>
                    </a:ln>
                    <a:solidFill>
                      <a:schemeClr val="bg2">
                        <a:tint val="85000"/>
                        <a:satMod val="155000"/>
                      </a:schemeClr>
                    </a:solidFill>
                    <a:effectLst>
                      <a:outerShdw blurRad="41275" dist="20320" dir="1800000" algn="tl" rotWithShape="0">
                        <a:srgbClr val="000000">
                          <a:alpha val="40000"/>
                        </a:srgbClr>
                      </a:outerShdw>
                    </a:effectLst>
                  </a:endParaRPr>
                </a:p>
              </p:txBody>
            </p:sp>
          </p:grpSp>
          <p:grpSp>
            <p:nvGrpSpPr>
              <p:cNvPr id="45" name="Group 44"/>
              <p:cNvGrpSpPr/>
              <p:nvPr/>
            </p:nvGrpSpPr>
            <p:grpSpPr>
              <a:xfrm>
                <a:off x="4855971" y="1834609"/>
                <a:ext cx="2361272" cy="544573"/>
                <a:chOff x="4371398" y="1173086"/>
                <a:chExt cx="2361272" cy="544573"/>
              </a:xfrm>
            </p:grpSpPr>
            <p:sp>
              <p:nvSpPr>
                <p:cNvPr id="46" name="TextBox 45"/>
                <p:cNvSpPr txBox="1"/>
                <p:nvPr/>
              </p:nvSpPr>
              <p:spPr>
                <a:xfrm>
                  <a:off x="4444572" y="1173086"/>
                  <a:ext cx="2288098" cy="54457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αPD-1+BLZ945</a:t>
                  </a:r>
                  <a:endParaRPr lang="sv-SE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" name="Flowchart: Connector 46"/>
                <p:cNvSpPr/>
                <p:nvPr/>
              </p:nvSpPr>
              <p:spPr>
                <a:xfrm>
                  <a:off x="4371398" y="1344604"/>
                  <a:ext cx="161959" cy="180001"/>
                </a:xfrm>
                <a:prstGeom prst="flowChartConnector">
                  <a:avLst/>
                </a:prstGeom>
                <a:solidFill>
                  <a:srgbClr val="FF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3">
                    <a:shade val="50000"/>
                  </a:schemeClr>
                </a:lnRef>
                <a:fillRef idx="1">
                  <a:schemeClr val="accent3"/>
                </a:fillRef>
                <a:effectRef idx="0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sv-SE" sz="800" b="1">
                    <a:ln w="12700">
                      <a:solidFill>
                        <a:schemeClr val="tx2">
                          <a:satMod val="155000"/>
                        </a:schemeClr>
                      </a:solidFill>
                      <a:prstDash val="solid"/>
                    </a:ln>
                    <a:solidFill>
                      <a:schemeClr val="bg2">
                        <a:tint val="85000"/>
                        <a:satMod val="155000"/>
                      </a:schemeClr>
                    </a:solidFill>
                    <a:effectLst>
                      <a:outerShdw blurRad="41275" dist="20320" dir="1800000" algn="tl" rotWithShape="0">
                        <a:srgbClr val="000000">
                          <a:alpha val="40000"/>
                        </a:srgbClr>
                      </a:outerShdw>
                    </a:effectLst>
                  </a:endParaRPr>
                </a:p>
              </p:txBody>
            </p:sp>
          </p:grpSp>
        </p:grpSp>
        <p:sp>
          <p:nvSpPr>
            <p:cNvPr id="56" name="TextBox 55"/>
            <p:cNvSpPr txBox="1"/>
            <p:nvPr/>
          </p:nvSpPr>
          <p:spPr>
            <a:xfrm>
              <a:off x="1104017" y="2194381"/>
              <a:ext cx="126770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ircle: 95% CI</a:t>
              </a:r>
              <a:endParaRPr lang="sv-S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TextBox 3"/>
          <p:cNvSpPr txBox="1"/>
          <p:nvPr/>
        </p:nvSpPr>
        <p:spPr>
          <a:xfrm>
            <a:off x="7315200" y="1312977"/>
            <a:ext cx="175881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. = naive</a:t>
            </a:r>
          </a:p>
          <a:p>
            <a:r>
              <a:rPr lang="sv-S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.-b.= tumor-bearing</a:t>
            </a:r>
            <a:endParaRPr lang="sv-S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81561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412750" y="4495800"/>
            <a:ext cx="3968663" cy="2344738"/>
            <a:chOff x="-6263" y="2979164"/>
            <a:chExt cx="3968663" cy="2344738"/>
          </a:xfrm>
        </p:grpSpPr>
        <p:graphicFrame>
          <p:nvGraphicFramePr>
            <p:cNvPr id="15" name="Object 1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373845"/>
                </p:ext>
              </p:extLst>
            </p:nvPr>
          </p:nvGraphicFramePr>
          <p:xfrm>
            <a:off x="-6263" y="3256977"/>
            <a:ext cx="2247900" cy="2066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55" name="Prism 6" r:id="rId3" imgW="2875315" imgH="2634559" progId="Prism6.Document">
                    <p:embed/>
                  </p:oleObj>
                </mc:Choice>
                <mc:Fallback>
                  <p:oleObj name="Prism 6" r:id="rId3" imgW="2875315" imgH="2634559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-6263" y="3256977"/>
                          <a:ext cx="2247900" cy="20669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Object 1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99751231"/>
                </p:ext>
              </p:extLst>
            </p:nvPr>
          </p:nvGraphicFramePr>
          <p:xfrm>
            <a:off x="1978025" y="3333342"/>
            <a:ext cx="1984375" cy="19843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56" name="Prism 6" r:id="rId5" imgW="2620827" imgH="2619441" progId="Prism6.Document">
                    <p:embed/>
                  </p:oleObj>
                </mc:Choice>
                <mc:Fallback>
                  <p:oleObj name="Prism 6" r:id="rId5" imgW="2620827" imgH="2619441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978025" y="3333342"/>
                          <a:ext cx="1984375" cy="19843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" name="TextBox 15"/>
            <p:cNvSpPr txBox="1"/>
            <p:nvPr/>
          </p:nvSpPr>
          <p:spPr>
            <a:xfrm>
              <a:off x="425220" y="2979164"/>
              <a:ext cx="5485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  <a:endParaRPr lang="sv-SE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914400" y="3096730"/>
              <a:ext cx="5164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8+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607712" y="3096730"/>
              <a:ext cx="5164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4+</a:t>
              </a:r>
              <a:endParaRPr lang="sv-SE" sz="1000" dirty="0">
                <a:latin typeface="Symbol" panose="05050102010706020507" pitchFamily="18" charset="2"/>
              </a:endParaRPr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-36513" y="24879"/>
            <a:ext cx="87745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sv-S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hemokine expression in immune cells and T-cell infiltration after CXCR3 blockade.</a:t>
            </a:r>
            <a:endParaRPr lang="sv-S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64852" y="3901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sv-S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4852" y="42788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sv-S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140805" y="2309745"/>
            <a:ext cx="6449638" cy="2186055"/>
            <a:chOff x="127981" y="574766"/>
            <a:chExt cx="6449638" cy="2186055"/>
          </a:xfrm>
        </p:grpSpPr>
        <p:sp>
          <p:nvSpPr>
            <p:cNvPr id="27" name="TextBox 26"/>
            <p:cNvSpPr txBox="1"/>
            <p:nvPr/>
          </p:nvSpPr>
          <p:spPr>
            <a:xfrm>
              <a:off x="3200400" y="2514600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XCL9</a:t>
              </a:r>
              <a:endParaRPr lang="sv-SE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127981" y="574766"/>
              <a:ext cx="6449638" cy="1869758"/>
              <a:chOff x="230562" y="3007042"/>
              <a:chExt cx="6449638" cy="1869758"/>
            </a:xfrm>
          </p:grpSpPr>
          <p:graphicFrame>
            <p:nvGraphicFramePr>
              <p:cNvPr id="22" name="Object 21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924587044"/>
                  </p:ext>
                </p:extLst>
              </p:nvPr>
            </p:nvGraphicFramePr>
            <p:xfrm>
              <a:off x="230562" y="3217863"/>
              <a:ext cx="1830387" cy="15017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757" name="Prism 6" r:id="rId7" imgW="2418173" imgH="1984108" progId="Prism6.Document">
                      <p:embed/>
                    </p:oleObj>
                  </mc:Choice>
                  <mc:Fallback>
                    <p:oleObj name="Prism 6" r:id="rId7" imgW="2418173" imgH="1984108" progId="Prism6.Document">
                      <p:embed/>
                      <p:pic>
                        <p:nvPicPr>
                          <p:cNvPr id="0" name="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8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230562" y="3217863"/>
                            <a:ext cx="1830387" cy="150177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3" name="Object 2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391634349"/>
                  </p:ext>
                </p:extLst>
              </p:nvPr>
            </p:nvGraphicFramePr>
            <p:xfrm>
              <a:off x="3276600" y="3200400"/>
              <a:ext cx="1858963" cy="151923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758" name="Prism 6" r:id="rId9" imgW="2427532" imgH="1984108" progId="Prism6.Document">
                      <p:embed/>
                    </p:oleObj>
                  </mc:Choice>
                  <mc:Fallback>
                    <p:oleObj name="Prism 6" r:id="rId9" imgW="2427532" imgH="1984108" progId="Prism6.Document">
                      <p:embed/>
                      <p:pic>
                        <p:nvPicPr>
                          <p:cNvPr id="0" name="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10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3276600" y="3200400"/>
                            <a:ext cx="1858963" cy="1519238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4" name="Object 2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483184120"/>
                  </p:ext>
                </p:extLst>
              </p:nvPr>
            </p:nvGraphicFramePr>
            <p:xfrm>
              <a:off x="1752600" y="3217863"/>
              <a:ext cx="1776413" cy="15017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759" name="Prism 6" r:id="rId11" imgW="2345102" imgH="1984108" progId="Prism6.Document">
                      <p:embed/>
                    </p:oleObj>
                  </mc:Choice>
                  <mc:Fallback>
                    <p:oleObj name="Prism 6" r:id="rId11" imgW="2345102" imgH="1984108" progId="Prism6.Document">
                      <p:embed/>
                      <p:pic>
                        <p:nvPicPr>
                          <p:cNvPr id="0" name="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12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752600" y="3217863"/>
                            <a:ext cx="1776413" cy="150177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5" name="Object 2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168053976"/>
                  </p:ext>
                </p:extLst>
              </p:nvPr>
            </p:nvGraphicFramePr>
            <p:xfrm>
              <a:off x="4953000" y="3248026"/>
              <a:ext cx="1727200" cy="147161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760" name="Prism 6" r:id="rId13" imgW="2285710" imgH="1947392" progId="Prism6.Document">
                      <p:embed/>
                    </p:oleObj>
                  </mc:Choice>
                  <mc:Fallback>
                    <p:oleObj name="Prism 6" r:id="rId13" imgW="2285710" imgH="1947392" progId="Prism6.Document">
                      <p:embed/>
                      <p:pic>
                        <p:nvPicPr>
                          <p:cNvPr id="0" name="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14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4953000" y="3248026"/>
                            <a:ext cx="1727200" cy="1471612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/>
                        </p:spPr>
                      </p:pic>
                    </p:oleObj>
                  </mc:Fallback>
                </mc:AlternateContent>
              </a:graphicData>
            </a:graphic>
          </p:graphicFrame>
          <p:cxnSp>
            <p:nvCxnSpPr>
              <p:cNvPr id="26" name="Straight Arrow Connector 25"/>
              <p:cNvCxnSpPr/>
              <p:nvPr/>
            </p:nvCxnSpPr>
            <p:spPr>
              <a:xfrm>
                <a:off x="1447800" y="4876800"/>
                <a:ext cx="4636983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extBox 27"/>
              <p:cNvSpPr txBox="1"/>
              <p:nvPr/>
            </p:nvSpPr>
            <p:spPr>
              <a:xfrm>
                <a:off x="762000" y="3007042"/>
                <a:ext cx="84670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D4 T cells</a:t>
                </a:r>
                <a:endParaRPr lang="sv-SE" sz="1000" dirty="0">
                  <a:latin typeface="Symbol" panose="05050102010706020507" pitchFamily="18" charset="2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2209800" y="3007042"/>
                <a:ext cx="91723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D8a T cells</a:t>
                </a:r>
                <a:endParaRPr lang="sv-SE" sz="1000" dirty="0">
                  <a:latin typeface="Symbol" panose="05050102010706020507" pitchFamily="18" charset="2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3949438" y="3007042"/>
                <a:ext cx="5613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 cells</a:t>
                </a:r>
                <a:endParaRPr lang="sv-SE" sz="1000" dirty="0">
                  <a:latin typeface="Symbol" panose="05050102010706020507" pitchFamily="18" charset="2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5288739" y="3007042"/>
                <a:ext cx="103586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D-2 synthase</a:t>
                </a:r>
                <a:endParaRPr lang="sv-SE" sz="1000" dirty="0">
                  <a:latin typeface="Symbol" panose="05050102010706020507" pitchFamily="18" charset="2"/>
                </a:endParaRPr>
              </a:p>
            </p:txBody>
          </p:sp>
        </p:grpSp>
      </p:grpSp>
      <p:sp>
        <p:nvSpPr>
          <p:cNvPr id="32" name="TextBox 31"/>
          <p:cNvSpPr txBox="1"/>
          <p:nvPr/>
        </p:nvSpPr>
        <p:spPr>
          <a:xfrm>
            <a:off x="64852" y="21336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sv-S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95441611"/>
              </p:ext>
            </p:extLst>
          </p:nvPr>
        </p:nvGraphicFramePr>
        <p:xfrm>
          <a:off x="241424" y="533400"/>
          <a:ext cx="1582345" cy="15771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61" name="Prism 6" r:id="rId15" imgW="2427532" imgH="2420022" progId="Prism6.Document">
                  <p:embed/>
                </p:oleObj>
              </mc:Choice>
              <mc:Fallback>
                <p:oleObj name="Prism 6" r:id="rId15" imgW="2427532" imgH="242002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41424" y="533400"/>
                        <a:ext cx="1582345" cy="15771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57912526"/>
              </p:ext>
            </p:extLst>
          </p:nvPr>
        </p:nvGraphicFramePr>
        <p:xfrm>
          <a:off x="1841624" y="533400"/>
          <a:ext cx="1582345" cy="15771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62" name="Prism 6" r:id="rId17" imgW="2427532" imgH="2420022" progId="Prism6.Document">
                  <p:embed/>
                </p:oleObj>
              </mc:Choice>
              <mc:Fallback>
                <p:oleObj name="Prism 6" r:id="rId17" imgW="2427532" imgH="242002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1841624" y="533400"/>
                        <a:ext cx="1582345" cy="15771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36189085"/>
              </p:ext>
            </p:extLst>
          </p:nvPr>
        </p:nvGraphicFramePr>
        <p:xfrm>
          <a:off x="3518024" y="533400"/>
          <a:ext cx="1582345" cy="15771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63" name="Prism 6" r:id="rId19" imgW="2427532" imgH="2420022" progId="Prism6.Document">
                  <p:embed/>
                </p:oleObj>
              </mc:Choice>
              <mc:Fallback>
                <p:oleObj name="Prism 6" r:id="rId19" imgW="2427532" imgH="242002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3518024" y="533400"/>
                        <a:ext cx="1582345" cy="15771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540171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92" name="Picture 4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312" y="3654623"/>
            <a:ext cx="3192474" cy="26527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0" y="11668"/>
            <a:ext cx="8991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sv-SE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In vitro </a:t>
            </a:r>
            <a:r>
              <a:rPr lang="sv-S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ultures displaying T-cell activation.</a:t>
            </a:r>
            <a:endParaRPr lang="sv-S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3930630" y="824508"/>
            <a:ext cx="3455506" cy="1875259"/>
            <a:chOff x="2040771" y="2919861"/>
            <a:chExt cx="3455506" cy="1875259"/>
          </a:xfrm>
        </p:grpSpPr>
        <p:grpSp>
          <p:nvGrpSpPr>
            <p:cNvPr id="7" name="Group 6"/>
            <p:cNvGrpSpPr/>
            <p:nvPr/>
          </p:nvGrpSpPr>
          <p:grpSpPr>
            <a:xfrm>
              <a:off x="2040771" y="2928408"/>
              <a:ext cx="2032827" cy="1518776"/>
              <a:chOff x="1050171" y="996606"/>
              <a:chExt cx="2032827" cy="1518776"/>
            </a:xfrm>
          </p:grpSpPr>
          <p:pic>
            <p:nvPicPr>
              <p:cNvPr id="14" name="Picture 4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02556" y="1279269"/>
                <a:ext cx="1276756" cy="122635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15" name="Straight Arrow Connector 14"/>
              <p:cNvCxnSpPr/>
              <p:nvPr/>
            </p:nvCxnSpPr>
            <p:spPr>
              <a:xfrm flipV="1">
                <a:off x="1406598" y="1524782"/>
                <a:ext cx="0" cy="99060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 rot="16200000">
                <a:off x="798226" y="1855001"/>
                <a:ext cx="81166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SC</a:t>
                </a:r>
                <a:endParaRPr lang="sv-S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2261319" y="1316051"/>
                <a:ext cx="8216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.1%</a:t>
                </a:r>
                <a:endParaRPr lang="sv-S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1939998" y="996606"/>
                <a:ext cx="1143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BMC</a:t>
                </a:r>
                <a:endParaRPr lang="sv-S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3971677" y="2919861"/>
              <a:ext cx="1524600" cy="1527323"/>
              <a:chOff x="2981077" y="988059"/>
              <a:chExt cx="1524600" cy="1527323"/>
            </a:xfrm>
          </p:grpSpPr>
          <p:pic>
            <p:nvPicPr>
              <p:cNvPr id="11" name="Picture 2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81077" y="1269513"/>
                <a:ext cx="1297069" cy="124586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2" name="TextBox 11"/>
              <p:cNvSpPr txBox="1"/>
              <p:nvPr/>
            </p:nvSpPr>
            <p:spPr>
              <a:xfrm>
                <a:off x="3768798" y="1316051"/>
                <a:ext cx="609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.6%</a:t>
                </a:r>
                <a:endParaRPr lang="sv-S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3006798" y="988059"/>
                <a:ext cx="14988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ono-depleted</a:t>
                </a:r>
                <a:endParaRPr lang="sv-S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" name="TextBox 8"/>
            <p:cNvSpPr txBox="1"/>
            <p:nvPr/>
          </p:nvSpPr>
          <p:spPr>
            <a:xfrm>
              <a:off x="3400777" y="4487343"/>
              <a:ext cx="20955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  <a:endParaRPr lang="sv-S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" name="Straight Arrow Connector 9"/>
            <p:cNvCxnSpPr/>
            <p:nvPr/>
          </p:nvCxnSpPr>
          <p:spPr>
            <a:xfrm>
              <a:off x="2593156" y="4639743"/>
              <a:ext cx="6858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" name="TextBox 18"/>
          <p:cNvSpPr txBox="1"/>
          <p:nvPr/>
        </p:nvSpPr>
        <p:spPr>
          <a:xfrm>
            <a:off x="76200" y="418962"/>
            <a:ext cx="811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sv-S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707676" y="418962"/>
            <a:ext cx="811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40" name="Group 39"/>
          <p:cNvGrpSpPr/>
          <p:nvPr/>
        </p:nvGrpSpPr>
        <p:grpSpPr>
          <a:xfrm>
            <a:off x="5857798" y="3755057"/>
            <a:ext cx="3227387" cy="2950543"/>
            <a:chOff x="3882819" y="3654623"/>
            <a:chExt cx="3227387" cy="2950543"/>
          </a:xfrm>
        </p:grpSpPr>
        <p:graphicFrame>
          <p:nvGraphicFramePr>
            <p:cNvPr id="38" name="Object 3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28704475"/>
                </p:ext>
              </p:extLst>
            </p:nvPr>
          </p:nvGraphicFramePr>
          <p:xfrm>
            <a:off x="3882819" y="3695700"/>
            <a:ext cx="3227387" cy="290946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82" name="Prism 6" r:id="rId6" imgW="3297541" imgH="2971483" progId="Prism6.Document">
                    <p:embed/>
                  </p:oleObj>
                </mc:Choice>
                <mc:Fallback>
                  <p:oleObj name="Prism 6" r:id="rId6" imgW="3297541" imgH="2971483" progId="Prism6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7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882819" y="3695700"/>
                          <a:ext cx="3227387" cy="2909466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9" name="TextBox 38"/>
            <p:cNvSpPr txBox="1"/>
            <p:nvPr/>
          </p:nvSpPr>
          <p:spPr>
            <a:xfrm>
              <a:off x="4876800" y="3654623"/>
              <a:ext cx="142996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no-depleted</a:t>
              </a:r>
              <a:endParaRPr lang="sv-S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1" name="TextBox 40"/>
          <p:cNvSpPr txBox="1"/>
          <p:nvPr/>
        </p:nvSpPr>
        <p:spPr>
          <a:xfrm>
            <a:off x="34577" y="3417991"/>
            <a:ext cx="811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45" name="Group 44"/>
          <p:cNvGrpSpPr/>
          <p:nvPr/>
        </p:nvGrpSpPr>
        <p:grpSpPr>
          <a:xfrm>
            <a:off x="3569177" y="3692128"/>
            <a:ext cx="1977617" cy="2306915"/>
            <a:chOff x="90100" y="2364237"/>
            <a:chExt cx="1977617" cy="2306915"/>
          </a:xfrm>
        </p:grpSpPr>
        <p:sp>
          <p:nvSpPr>
            <p:cNvPr id="46" name="TextBox 45"/>
            <p:cNvSpPr txBox="1"/>
            <p:nvPr/>
          </p:nvSpPr>
          <p:spPr>
            <a:xfrm>
              <a:off x="745723" y="4363375"/>
              <a:ext cx="115363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SF-1R</a:t>
              </a:r>
              <a:endParaRPr lang="sv-S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7" name="Group 46"/>
            <p:cNvGrpSpPr/>
            <p:nvPr/>
          </p:nvGrpSpPr>
          <p:grpSpPr>
            <a:xfrm>
              <a:off x="90100" y="2364237"/>
              <a:ext cx="1977617" cy="1995614"/>
              <a:chOff x="90100" y="2364237"/>
              <a:chExt cx="1977617" cy="1995614"/>
            </a:xfrm>
          </p:grpSpPr>
          <p:grpSp>
            <p:nvGrpSpPr>
              <p:cNvPr id="48" name="Group 47"/>
              <p:cNvGrpSpPr/>
              <p:nvPr/>
            </p:nvGrpSpPr>
            <p:grpSpPr>
              <a:xfrm>
                <a:off x="90100" y="2690870"/>
                <a:ext cx="1842068" cy="1668981"/>
                <a:chOff x="90100" y="2690870"/>
                <a:chExt cx="1842068" cy="1668981"/>
              </a:xfrm>
            </p:grpSpPr>
            <p:pic>
              <p:nvPicPr>
                <p:cNvPr id="51" name="Picture 7"/>
                <p:cNvPicPr>
                  <a:picLocks noChangeAspect="1" noChangeArrowheads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10246" y="2765234"/>
                  <a:ext cx="1621922" cy="159461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52" name="TextBox 51"/>
                <p:cNvSpPr txBox="1"/>
                <p:nvPr/>
              </p:nvSpPr>
              <p:spPr>
                <a:xfrm rot="16200000">
                  <a:off x="-594461" y="3375431"/>
                  <a:ext cx="16461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ized to Mode</a:t>
                  </a:r>
                  <a:endParaRPr lang="sv-SE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9" name="TextBox 48"/>
              <p:cNvSpPr txBox="1"/>
              <p:nvPr/>
            </p:nvSpPr>
            <p:spPr>
              <a:xfrm>
                <a:off x="1137353" y="2890017"/>
                <a:ext cx="93036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yeloid</a:t>
                </a:r>
              </a:p>
              <a:p>
                <a:r>
                  <a:rPr lang="sv-SE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FI: 485</a:t>
                </a:r>
                <a:endParaRPr lang="sv-SE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451553" y="2364237"/>
                <a:ext cx="108797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ymphocytes</a:t>
                </a:r>
              </a:p>
              <a:p>
                <a:r>
                  <a:rPr lang="sv-SE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FI: 21.4</a:t>
                </a:r>
                <a:endParaRPr lang="sv-SE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79" name="TextBox 78"/>
          <p:cNvSpPr txBox="1"/>
          <p:nvPr/>
        </p:nvSpPr>
        <p:spPr>
          <a:xfrm>
            <a:off x="3303133" y="3429000"/>
            <a:ext cx="811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5698403" y="3429000"/>
            <a:ext cx="811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sv-S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248660" y="685800"/>
            <a:ext cx="3355778" cy="1984177"/>
            <a:chOff x="3883222" y="352689"/>
            <a:chExt cx="3355778" cy="1984177"/>
          </a:xfrm>
        </p:grpSpPr>
        <p:grpSp>
          <p:nvGrpSpPr>
            <p:cNvPr id="24" name="Group 23"/>
            <p:cNvGrpSpPr/>
            <p:nvPr/>
          </p:nvGrpSpPr>
          <p:grpSpPr>
            <a:xfrm>
              <a:off x="3883222" y="532204"/>
              <a:ext cx="3355778" cy="1804662"/>
              <a:chOff x="612667" y="273198"/>
              <a:chExt cx="3355778" cy="1804662"/>
            </a:xfrm>
          </p:grpSpPr>
          <p:grpSp>
            <p:nvGrpSpPr>
              <p:cNvPr id="25" name="Group 24"/>
              <p:cNvGrpSpPr/>
              <p:nvPr/>
            </p:nvGrpSpPr>
            <p:grpSpPr>
              <a:xfrm>
                <a:off x="612667" y="273198"/>
                <a:ext cx="2078387" cy="1804662"/>
                <a:chOff x="612667" y="672411"/>
                <a:chExt cx="2078387" cy="1804662"/>
              </a:xfrm>
            </p:grpSpPr>
            <p:cxnSp>
              <p:nvCxnSpPr>
                <p:cNvPr id="32" name="Straight Arrow Connector 31"/>
                <p:cNvCxnSpPr/>
                <p:nvPr/>
              </p:nvCxnSpPr>
              <p:spPr>
                <a:xfrm>
                  <a:off x="1128195" y="2321696"/>
                  <a:ext cx="809921" cy="0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" name="TextBox 32"/>
                <p:cNvSpPr txBox="1"/>
                <p:nvPr/>
              </p:nvSpPr>
              <p:spPr>
                <a:xfrm>
                  <a:off x="1929054" y="2169296"/>
                  <a:ext cx="7620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FSE</a:t>
                  </a:r>
                  <a:endParaRPr lang="sv-SE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4" name="Straight Arrow Connector 33"/>
                <p:cNvCxnSpPr/>
                <p:nvPr/>
              </p:nvCxnSpPr>
              <p:spPr>
                <a:xfrm flipH="1" flipV="1">
                  <a:off x="996645" y="1399659"/>
                  <a:ext cx="1" cy="742647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" name="TextBox 34"/>
                <p:cNvSpPr txBox="1"/>
                <p:nvPr/>
              </p:nvSpPr>
              <p:spPr>
                <a:xfrm rot="16200000">
                  <a:off x="4556" y="1280522"/>
                  <a:ext cx="15240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XCR3</a:t>
                  </a:r>
                  <a:endParaRPr lang="sv-SE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6" name="Group 25"/>
              <p:cNvGrpSpPr/>
              <p:nvPr/>
            </p:nvGrpSpPr>
            <p:grpSpPr>
              <a:xfrm>
                <a:off x="1028817" y="404437"/>
                <a:ext cx="1524000" cy="1374990"/>
                <a:chOff x="1028817" y="404437"/>
                <a:chExt cx="1524000" cy="1374990"/>
              </a:xfrm>
            </p:grpSpPr>
            <p:pic>
              <p:nvPicPr>
                <p:cNvPr id="30" name="Picture 3"/>
                <p:cNvPicPr>
                  <a:picLocks noChangeAspect="1" noChangeArrowheads="1"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099911" y="652126"/>
                  <a:ext cx="1146604" cy="112730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31" name="TextBox 30"/>
                <p:cNvSpPr txBox="1"/>
                <p:nvPr/>
              </p:nvSpPr>
              <p:spPr>
                <a:xfrm>
                  <a:off x="1028817" y="404437"/>
                  <a:ext cx="15240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aive T cells</a:t>
                  </a:r>
                  <a:endParaRPr lang="sv-SE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7" name="Group 26"/>
              <p:cNvGrpSpPr/>
              <p:nvPr/>
            </p:nvGrpSpPr>
            <p:grpSpPr>
              <a:xfrm>
                <a:off x="2215845" y="401460"/>
                <a:ext cx="1752600" cy="1374577"/>
                <a:chOff x="2215845" y="401460"/>
                <a:chExt cx="1752600" cy="1374577"/>
              </a:xfrm>
            </p:grpSpPr>
            <p:pic>
              <p:nvPicPr>
                <p:cNvPr id="28" name="Picture 2"/>
                <p:cNvPicPr>
                  <a:picLocks noChangeAspect="1" noChangeArrowheads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444445" y="664947"/>
                  <a:ext cx="1130116" cy="111109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9" name="TextBox 28"/>
                <p:cNvSpPr txBox="1"/>
                <p:nvPr/>
              </p:nvSpPr>
              <p:spPr>
                <a:xfrm>
                  <a:off x="2215845" y="401460"/>
                  <a:ext cx="17526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l-GR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sv-SE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D3/CD28</a:t>
                  </a:r>
                  <a:endParaRPr lang="sv-SE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53" name="TextBox 52"/>
            <p:cNvSpPr txBox="1"/>
            <p:nvPr/>
          </p:nvSpPr>
          <p:spPr>
            <a:xfrm>
              <a:off x="4876800" y="352689"/>
              <a:ext cx="17526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+ T cells</a:t>
              </a:r>
              <a:endParaRPr lang="sv-S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592644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11668"/>
            <a:ext cx="8991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sv-S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-CSF is released by activated T cells.</a:t>
            </a:r>
            <a:endParaRPr lang="sv-S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76200" y="418962"/>
            <a:ext cx="811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sv-S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3" name="Group 102"/>
          <p:cNvGrpSpPr/>
          <p:nvPr/>
        </p:nvGrpSpPr>
        <p:grpSpPr>
          <a:xfrm>
            <a:off x="6221176" y="3819624"/>
            <a:ext cx="2352675" cy="2733576"/>
            <a:chOff x="6615113" y="1293911"/>
            <a:chExt cx="2352675" cy="2733576"/>
          </a:xfrm>
        </p:grpSpPr>
        <p:graphicFrame>
          <p:nvGraphicFramePr>
            <p:cNvPr id="101" name="Object 10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67233535"/>
                </p:ext>
              </p:extLst>
            </p:nvPr>
          </p:nvGraphicFramePr>
          <p:xfrm>
            <a:off x="6615113" y="1447800"/>
            <a:ext cx="2352675" cy="2579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206" name="Prism 6" r:id="rId3" imgW="2352661" imgH="2579845" progId="Prism6.Document">
                    <p:embed/>
                  </p:oleObj>
                </mc:Choice>
                <mc:Fallback>
                  <p:oleObj name="Prism 6" r:id="rId3" imgW="2352661" imgH="2579845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6615113" y="1447800"/>
                          <a:ext cx="2352675" cy="2579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5" name="TextBox 104"/>
            <p:cNvSpPr txBox="1"/>
            <p:nvPr/>
          </p:nvSpPr>
          <p:spPr>
            <a:xfrm>
              <a:off x="7581900" y="1293911"/>
              <a:ext cx="838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-CSF</a:t>
              </a:r>
              <a:endParaRPr lang="sv-S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6" name="Group 105"/>
          <p:cNvGrpSpPr/>
          <p:nvPr/>
        </p:nvGrpSpPr>
        <p:grpSpPr>
          <a:xfrm>
            <a:off x="516786" y="4298290"/>
            <a:ext cx="5171570" cy="2186224"/>
            <a:chOff x="409405" y="4537889"/>
            <a:chExt cx="5171570" cy="2186224"/>
          </a:xfrm>
        </p:grpSpPr>
        <p:grpSp>
          <p:nvGrpSpPr>
            <p:cNvPr id="108" name="Group 107"/>
            <p:cNvGrpSpPr/>
            <p:nvPr/>
          </p:nvGrpSpPr>
          <p:grpSpPr>
            <a:xfrm>
              <a:off x="3223570" y="4818692"/>
              <a:ext cx="1524000" cy="1343246"/>
              <a:chOff x="4193556" y="2766258"/>
              <a:chExt cx="1524000" cy="1343246"/>
            </a:xfrm>
          </p:grpSpPr>
          <p:grpSp>
            <p:nvGrpSpPr>
              <p:cNvPr id="109" name="Group 108"/>
              <p:cNvGrpSpPr/>
              <p:nvPr/>
            </p:nvGrpSpPr>
            <p:grpSpPr>
              <a:xfrm>
                <a:off x="4193556" y="2766258"/>
                <a:ext cx="1524000" cy="1343246"/>
                <a:chOff x="4193556" y="422553"/>
                <a:chExt cx="1524000" cy="1343246"/>
              </a:xfrm>
            </p:grpSpPr>
            <p:pic>
              <p:nvPicPr>
                <p:cNvPr id="111" name="Picture 5"/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300164" y="685799"/>
                  <a:ext cx="1098495" cy="1080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12" name="TextBox 111"/>
                <p:cNvSpPr txBox="1"/>
                <p:nvPr/>
              </p:nvSpPr>
              <p:spPr>
                <a:xfrm>
                  <a:off x="4193556" y="422553"/>
                  <a:ext cx="15240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6:1</a:t>
                  </a:r>
                  <a:endParaRPr lang="sv-SE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10" name="TextBox 109"/>
              <p:cNvSpPr txBox="1"/>
              <p:nvPr/>
            </p:nvSpPr>
            <p:spPr>
              <a:xfrm>
                <a:off x="4636016" y="3098859"/>
                <a:ext cx="8529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.54%</a:t>
                </a:r>
                <a:endParaRPr lang="sv-SE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3" name="Group 112"/>
            <p:cNvGrpSpPr/>
            <p:nvPr/>
          </p:nvGrpSpPr>
          <p:grpSpPr>
            <a:xfrm>
              <a:off x="986502" y="4840624"/>
              <a:ext cx="1098495" cy="1315823"/>
              <a:chOff x="952316" y="468429"/>
              <a:chExt cx="1098495" cy="1315823"/>
            </a:xfrm>
          </p:grpSpPr>
          <p:grpSp>
            <p:nvGrpSpPr>
              <p:cNvPr id="114" name="Group 113"/>
              <p:cNvGrpSpPr/>
              <p:nvPr/>
            </p:nvGrpSpPr>
            <p:grpSpPr>
              <a:xfrm>
                <a:off x="952316" y="704252"/>
                <a:ext cx="1098495" cy="1080000"/>
                <a:chOff x="533405" y="671922"/>
                <a:chExt cx="1098495" cy="1080000"/>
              </a:xfrm>
            </p:grpSpPr>
            <p:pic>
              <p:nvPicPr>
                <p:cNvPr id="116" name="Picture 3"/>
                <p:cNvPicPr>
                  <a:picLocks noChangeAspect="1" noChangeArrowheads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33405" y="671922"/>
                  <a:ext cx="1098495" cy="1080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17" name="TextBox 116"/>
                <p:cNvSpPr txBox="1"/>
                <p:nvPr/>
              </p:nvSpPr>
              <p:spPr>
                <a:xfrm>
                  <a:off x="832023" y="714491"/>
                  <a:ext cx="71059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2.2%</a:t>
                  </a:r>
                  <a:endParaRPr lang="sv-SE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15" name="TextBox 114"/>
              <p:cNvSpPr txBox="1"/>
              <p:nvPr/>
            </p:nvSpPr>
            <p:spPr>
              <a:xfrm>
                <a:off x="1160630" y="468429"/>
                <a:ext cx="83896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:1</a:t>
                </a:r>
                <a:endParaRPr lang="sv-SE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8" name="Group 117"/>
            <p:cNvGrpSpPr/>
            <p:nvPr/>
          </p:nvGrpSpPr>
          <p:grpSpPr>
            <a:xfrm>
              <a:off x="2178105" y="4841847"/>
              <a:ext cx="1098495" cy="1320091"/>
              <a:chOff x="2438405" y="445709"/>
              <a:chExt cx="1098495" cy="1320091"/>
            </a:xfrm>
          </p:grpSpPr>
          <p:grpSp>
            <p:nvGrpSpPr>
              <p:cNvPr id="119" name="Group 118"/>
              <p:cNvGrpSpPr/>
              <p:nvPr/>
            </p:nvGrpSpPr>
            <p:grpSpPr>
              <a:xfrm>
                <a:off x="2438405" y="685800"/>
                <a:ext cx="1098495" cy="1080000"/>
                <a:chOff x="2438405" y="685800"/>
                <a:chExt cx="1098495" cy="1080000"/>
              </a:xfrm>
            </p:grpSpPr>
            <p:pic>
              <p:nvPicPr>
                <p:cNvPr id="121" name="Picture 4"/>
                <p:cNvPicPr>
                  <a:picLocks noChangeAspect="1" noChangeArrowheads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438405" y="685800"/>
                  <a:ext cx="1098495" cy="1080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22" name="TextBox 121"/>
                <p:cNvSpPr txBox="1"/>
                <p:nvPr/>
              </p:nvSpPr>
              <p:spPr>
                <a:xfrm>
                  <a:off x="2735210" y="743486"/>
                  <a:ext cx="73538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3.89%</a:t>
                  </a:r>
                  <a:endParaRPr lang="sv-SE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20" name="TextBox 119"/>
              <p:cNvSpPr txBox="1"/>
              <p:nvPr/>
            </p:nvSpPr>
            <p:spPr>
              <a:xfrm>
                <a:off x="2653695" y="445709"/>
                <a:ext cx="81690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lang="sv-S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:1</a:t>
                </a:r>
                <a:endParaRPr lang="sv-SE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3" name="Group 122"/>
            <p:cNvGrpSpPr/>
            <p:nvPr/>
          </p:nvGrpSpPr>
          <p:grpSpPr>
            <a:xfrm>
              <a:off x="4464759" y="4814889"/>
              <a:ext cx="1116216" cy="1373461"/>
              <a:chOff x="6324602" y="392338"/>
              <a:chExt cx="1116216" cy="1373461"/>
            </a:xfrm>
          </p:grpSpPr>
          <p:grpSp>
            <p:nvGrpSpPr>
              <p:cNvPr id="124" name="Group 123"/>
              <p:cNvGrpSpPr/>
              <p:nvPr/>
            </p:nvGrpSpPr>
            <p:grpSpPr>
              <a:xfrm>
                <a:off x="6324602" y="685799"/>
                <a:ext cx="1116216" cy="1080000"/>
                <a:chOff x="6324602" y="685799"/>
                <a:chExt cx="1116216" cy="1080000"/>
              </a:xfrm>
            </p:grpSpPr>
            <p:pic>
              <p:nvPicPr>
                <p:cNvPr id="126" name="Picture 6"/>
                <p:cNvPicPr>
                  <a:picLocks noChangeAspect="1" noChangeArrowheads="1"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324602" y="685799"/>
                  <a:ext cx="1098495" cy="1080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27" name="TextBox 126"/>
                <p:cNvSpPr txBox="1"/>
                <p:nvPr/>
              </p:nvSpPr>
              <p:spPr>
                <a:xfrm>
                  <a:off x="6672028" y="728742"/>
                  <a:ext cx="76879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.01%</a:t>
                  </a:r>
                  <a:endParaRPr lang="sv-SE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25" name="TextBox 124"/>
              <p:cNvSpPr txBox="1"/>
              <p:nvPr/>
            </p:nvSpPr>
            <p:spPr>
              <a:xfrm>
                <a:off x="6677451" y="392338"/>
                <a:ext cx="66079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r>
                  <a:rPr lang="sv-S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:1</a:t>
                </a:r>
                <a:endParaRPr lang="sv-SE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28" name="Straight Arrow Connector 127"/>
            <p:cNvCxnSpPr/>
            <p:nvPr/>
          </p:nvCxnSpPr>
          <p:spPr>
            <a:xfrm>
              <a:off x="899658" y="6370915"/>
              <a:ext cx="3124199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9" name="TextBox 128"/>
            <p:cNvSpPr txBox="1"/>
            <p:nvPr/>
          </p:nvSpPr>
          <p:spPr>
            <a:xfrm>
              <a:off x="827973" y="6447114"/>
              <a:ext cx="15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FSE</a:t>
              </a:r>
              <a:endParaRPr lang="sv-S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0" name="Straight Arrow Connector 129"/>
            <p:cNvCxnSpPr/>
            <p:nvPr/>
          </p:nvCxnSpPr>
          <p:spPr>
            <a:xfrm flipH="1" flipV="1">
              <a:off x="747257" y="5207124"/>
              <a:ext cx="15845" cy="10668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1" name="TextBox 130"/>
            <p:cNvSpPr txBox="1"/>
            <p:nvPr/>
          </p:nvSpPr>
          <p:spPr>
            <a:xfrm rot="16200000">
              <a:off x="-214095" y="5553160"/>
              <a:ext cx="15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  <a:endParaRPr lang="sv-S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2256080" y="4539402"/>
              <a:ext cx="23157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BMC:alloMono</a:t>
              </a:r>
              <a:endParaRPr lang="sv-S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602877" y="4537889"/>
              <a:ext cx="23157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+ T cells</a:t>
              </a:r>
              <a:endParaRPr lang="sv-S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6" name="TextBox 135"/>
          <p:cNvSpPr txBox="1"/>
          <p:nvPr/>
        </p:nvSpPr>
        <p:spPr>
          <a:xfrm>
            <a:off x="76200" y="3781331"/>
            <a:ext cx="811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04" name="Group 103"/>
          <p:cNvGrpSpPr/>
          <p:nvPr/>
        </p:nvGrpSpPr>
        <p:grpSpPr>
          <a:xfrm>
            <a:off x="482033" y="381000"/>
            <a:ext cx="5565578" cy="3312115"/>
            <a:chOff x="-2978" y="230641"/>
            <a:chExt cx="5565578" cy="3312115"/>
          </a:xfrm>
        </p:grpSpPr>
        <p:grpSp>
          <p:nvGrpSpPr>
            <p:cNvPr id="107" name="Group 106"/>
            <p:cNvGrpSpPr/>
            <p:nvPr/>
          </p:nvGrpSpPr>
          <p:grpSpPr>
            <a:xfrm>
              <a:off x="-2978" y="1062115"/>
              <a:ext cx="967243" cy="2480641"/>
              <a:chOff x="222332" y="579444"/>
              <a:chExt cx="967243" cy="2480641"/>
            </a:xfrm>
          </p:grpSpPr>
          <p:cxnSp>
            <p:nvCxnSpPr>
              <p:cNvPr id="166" name="Straight Arrow Connector 165"/>
              <p:cNvCxnSpPr/>
              <p:nvPr/>
            </p:nvCxnSpPr>
            <p:spPr>
              <a:xfrm>
                <a:off x="445857" y="2752308"/>
                <a:ext cx="632273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7" name="TextBox 166"/>
              <p:cNvSpPr txBox="1"/>
              <p:nvPr/>
            </p:nvSpPr>
            <p:spPr>
              <a:xfrm>
                <a:off x="313275" y="2752308"/>
                <a:ext cx="8763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Ki67</a:t>
                </a:r>
                <a:endParaRPr lang="sv-S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8" name="Straight Arrow Connector 167"/>
              <p:cNvCxnSpPr/>
              <p:nvPr/>
            </p:nvCxnSpPr>
            <p:spPr>
              <a:xfrm flipV="1">
                <a:off x="380999" y="1948485"/>
                <a:ext cx="1" cy="688006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9" name="TextBox 168"/>
              <p:cNvSpPr txBox="1"/>
              <p:nvPr/>
            </p:nvSpPr>
            <p:spPr>
              <a:xfrm rot="16200000">
                <a:off x="-290528" y="1092304"/>
                <a:ext cx="133349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-CSF</a:t>
                </a:r>
                <a:endParaRPr lang="sv-S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4" name="TextBox 133"/>
            <p:cNvSpPr txBox="1"/>
            <p:nvPr/>
          </p:nvSpPr>
          <p:spPr>
            <a:xfrm>
              <a:off x="1724206" y="470890"/>
              <a:ext cx="302588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BMC, gated on CD3+ T cells</a:t>
              </a:r>
              <a:endParaRPr lang="sv-S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7" name="Group 136"/>
            <p:cNvGrpSpPr/>
            <p:nvPr/>
          </p:nvGrpSpPr>
          <p:grpSpPr>
            <a:xfrm>
              <a:off x="229820" y="230641"/>
              <a:ext cx="1328051" cy="1395094"/>
              <a:chOff x="228599" y="333048"/>
              <a:chExt cx="1868011" cy="2039335"/>
            </a:xfrm>
          </p:grpSpPr>
          <p:grpSp>
            <p:nvGrpSpPr>
              <p:cNvPr id="162" name="Group 161"/>
              <p:cNvGrpSpPr/>
              <p:nvPr/>
            </p:nvGrpSpPr>
            <p:grpSpPr>
              <a:xfrm>
                <a:off x="228599" y="649287"/>
                <a:ext cx="1752601" cy="1723096"/>
                <a:chOff x="533400" y="649287"/>
                <a:chExt cx="1752601" cy="1723096"/>
              </a:xfrm>
            </p:grpSpPr>
            <p:pic>
              <p:nvPicPr>
                <p:cNvPr id="164" name="Picture 2"/>
                <p:cNvPicPr>
                  <a:picLocks noChangeAspect="1" noChangeArrowheads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33400" y="649287"/>
                  <a:ext cx="1752601" cy="172309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65" name="TextBox 164"/>
                <p:cNvSpPr txBox="1"/>
                <p:nvPr/>
              </p:nvSpPr>
              <p:spPr>
                <a:xfrm>
                  <a:off x="1409700" y="1083646"/>
                  <a:ext cx="876301" cy="4049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.45%</a:t>
                  </a:r>
                  <a:endParaRPr lang="sv-SE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63" name="TextBox 162"/>
              <p:cNvSpPr txBox="1"/>
              <p:nvPr/>
            </p:nvSpPr>
            <p:spPr>
              <a:xfrm>
                <a:off x="623926" y="333048"/>
                <a:ext cx="1472684" cy="2616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o beads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8" name="Group 137"/>
            <p:cNvGrpSpPr/>
            <p:nvPr/>
          </p:nvGrpSpPr>
          <p:grpSpPr>
            <a:xfrm>
              <a:off x="275751" y="1634779"/>
              <a:ext cx="5286849" cy="1456411"/>
              <a:chOff x="2495418" y="825635"/>
              <a:chExt cx="5286849" cy="1456411"/>
            </a:xfrm>
          </p:grpSpPr>
          <p:grpSp>
            <p:nvGrpSpPr>
              <p:cNvPr id="142" name="Group 141"/>
              <p:cNvGrpSpPr/>
              <p:nvPr/>
            </p:nvGrpSpPr>
            <p:grpSpPr>
              <a:xfrm>
                <a:off x="2495418" y="838324"/>
                <a:ext cx="1246001" cy="1423925"/>
                <a:chOff x="2495418" y="838324"/>
                <a:chExt cx="1246001" cy="1423925"/>
              </a:xfrm>
            </p:grpSpPr>
            <p:grpSp>
              <p:nvGrpSpPr>
                <p:cNvPr id="158" name="Group 157"/>
                <p:cNvGrpSpPr/>
                <p:nvPr/>
              </p:nvGrpSpPr>
              <p:grpSpPr>
                <a:xfrm>
                  <a:off x="2495418" y="1083493"/>
                  <a:ext cx="1246001" cy="1178756"/>
                  <a:chOff x="2296719" y="638513"/>
                  <a:chExt cx="1752600" cy="1723095"/>
                </a:xfrm>
              </p:grpSpPr>
              <p:pic>
                <p:nvPicPr>
                  <p:cNvPr id="160" name="Picture 3"/>
                  <p:cNvPicPr>
                    <a:picLocks noChangeAspect="1" noChangeArrowheads="1"/>
                  </p:cNvPicPr>
                  <p:nvPr/>
                </p:nvPicPr>
                <p:blipFill>
                  <a:blip r:embed="rId1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296719" y="638513"/>
                    <a:ext cx="1752600" cy="1723095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161" name="TextBox 160"/>
                  <p:cNvSpPr txBox="1"/>
                  <p:nvPr/>
                </p:nvSpPr>
                <p:spPr>
                  <a:xfrm>
                    <a:off x="3162300" y="1083646"/>
                    <a:ext cx="876301" cy="4049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sv-SE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6.2%</a:t>
                    </a:r>
                    <a:endParaRPr lang="sv-SE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59" name="TextBox 158"/>
                <p:cNvSpPr txBox="1"/>
                <p:nvPr/>
              </p:nvSpPr>
              <p:spPr>
                <a:xfrm>
                  <a:off x="2875035" y="838324"/>
                  <a:ext cx="736341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11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.5 </a:t>
                  </a:r>
                  <a:r>
                    <a:rPr lang="el-GR" sz="11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sv-SE" sz="11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</a:t>
                  </a:r>
                  <a:endParaRPr lang="sv-SE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43" name="Group 142"/>
              <p:cNvGrpSpPr/>
              <p:nvPr/>
            </p:nvGrpSpPr>
            <p:grpSpPr>
              <a:xfrm>
                <a:off x="3845141" y="825635"/>
                <a:ext cx="1273088" cy="1444877"/>
                <a:chOff x="4251412" y="825635"/>
                <a:chExt cx="1273088" cy="1444877"/>
              </a:xfrm>
            </p:grpSpPr>
            <p:grpSp>
              <p:nvGrpSpPr>
                <p:cNvPr id="154" name="Group 153"/>
                <p:cNvGrpSpPr/>
                <p:nvPr/>
              </p:nvGrpSpPr>
              <p:grpSpPr>
                <a:xfrm>
                  <a:off x="4251412" y="1090863"/>
                  <a:ext cx="1273088" cy="1179649"/>
                  <a:chOff x="4114800" y="649288"/>
                  <a:chExt cx="1790700" cy="1724400"/>
                </a:xfrm>
              </p:grpSpPr>
              <p:pic>
                <p:nvPicPr>
                  <p:cNvPr id="156" name="Picture 4"/>
                  <p:cNvPicPr>
                    <a:picLocks noChangeAspect="1" noChangeArrowheads="1"/>
                  </p:cNvPicPr>
                  <p:nvPr/>
                </p:nvPicPr>
                <p:blipFill>
                  <a:blip r:embed="rId11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4114800" y="649288"/>
                    <a:ext cx="1753927" cy="1724400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157" name="TextBox 156"/>
                  <p:cNvSpPr txBox="1"/>
                  <p:nvPr/>
                </p:nvSpPr>
                <p:spPr>
                  <a:xfrm>
                    <a:off x="5029199" y="1085695"/>
                    <a:ext cx="876301" cy="4049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sv-SE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.6%</a:t>
                    </a:r>
                    <a:endParaRPr lang="sv-SE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55" name="TextBox 154"/>
                <p:cNvSpPr txBox="1"/>
                <p:nvPr/>
              </p:nvSpPr>
              <p:spPr>
                <a:xfrm>
                  <a:off x="4750059" y="825635"/>
                  <a:ext cx="736341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11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 </a:t>
                  </a:r>
                  <a:r>
                    <a:rPr lang="el-GR" sz="11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sv-SE" sz="11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</a:t>
                  </a:r>
                  <a:endParaRPr lang="sv-SE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44" name="Group 143"/>
              <p:cNvGrpSpPr/>
              <p:nvPr/>
            </p:nvGrpSpPr>
            <p:grpSpPr>
              <a:xfrm>
                <a:off x="5184227" y="839315"/>
                <a:ext cx="1273088" cy="1430305"/>
                <a:chOff x="6004012" y="839315"/>
                <a:chExt cx="1273088" cy="1430305"/>
              </a:xfrm>
            </p:grpSpPr>
            <p:grpSp>
              <p:nvGrpSpPr>
                <p:cNvPr id="150" name="Group 149"/>
                <p:cNvGrpSpPr/>
                <p:nvPr/>
              </p:nvGrpSpPr>
              <p:grpSpPr>
                <a:xfrm>
                  <a:off x="6004012" y="1090864"/>
                  <a:ext cx="1273088" cy="1178756"/>
                  <a:chOff x="5562600" y="649288"/>
                  <a:chExt cx="1790700" cy="1723095"/>
                </a:xfrm>
              </p:grpSpPr>
              <p:pic>
                <p:nvPicPr>
                  <p:cNvPr id="152" name="Picture 5"/>
                  <p:cNvPicPr>
                    <a:picLocks noChangeAspect="1" noChangeArrowheads="1"/>
                  </p:cNvPicPr>
                  <p:nvPr/>
                </p:nvPicPr>
                <p:blipFill>
                  <a:blip r:embed="rId1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5562600" y="649288"/>
                    <a:ext cx="1752600" cy="1723095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153" name="TextBox 152"/>
                  <p:cNvSpPr txBox="1"/>
                  <p:nvPr/>
                </p:nvSpPr>
                <p:spPr>
                  <a:xfrm>
                    <a:off x="6476999" y="1066800"/>
                    <a:ext cx="876301" cy="4049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sv-SE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6.4%</a:t>
                    </a:r>
                    <a:endParaRPr lang="sv-SE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51" name="TextBox 150"/>
                <p:cNvSpPr txBox="1"/>
                <p:nvPr/>
              </p:nvSpPr>
              <p:spPr>
                <a:xfrm>
                  <a:off x="6478075" y="839315"/>
                  <a:ext cx="736341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11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 </a:t>
                  </a:r>
                  <a:r>
                    <a:rPr lang="el-GR" sz="11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sv-SE" sz="11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</a:t>
                  </a:r>
                  <a:endParaRPr lang="sv-SE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45" name="Group 144"/>
              <p:cNvGrpSpPr/>
              <p:nvPr/>
            </p:nvGrpSpPr>
            <p:grpSpPr>
              <a:xfrm>
                <a:off x="6502304" y="825635"/>
                <a:ext cx="1279963" cy="1456411"/>
                <a:chOff x="7759407" y="801477"/>
                <a:chExt cx="1279963" cy="1456411"/>
              </a:xfrm>
            </p:grpSpPr>
            <p:grpSp>
              <p:nvGrpSpPr>
                <p:cNvPr id="146" name="Group 145"/>
                <p:cNvGrpSpPr/>
                <p:nvPr/>
              </p:nvGrpSpPr>
              <p:grpSpPr>
                <a:xfrm>
                  <a:off x="7759407" y="1075776"/>
                  <a:ext cx="1279963" cy="1182112"/>
                  <a:chOff x="7696200" y="602321"/>
                  <a:chExt cx="1800371" cy="1728000"/>
                </a:xfrm>
              </p:grpSpPr>
              <p:pic>
                <p:nvPicPr>
                  <p:cNvPr id="148" name="Picture 6"/>
                  <p:cNvPicPr>
                    <a:picLocks noChangeAspect="1" noChangeArrowheads="1"/>
                  </p:cNvPicPr>
                  <p:nvPr/>
                </p:nvPicPr>
                <p:blipFill>
                  <a:blip r:embed="rId1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7696200" y="602321"/>
                    <a:ext cx="1757589" cy="1728000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149" name="TextBox 148"/>
                  <p:cNvSpPr txBox="1"/>
                  <p:nvPr/>
                </p:nvSpPr>
                <p:spPr>
                  <a:xfrm>
                    <a:off x="8620271" y="1034920"/>
                    <a:ext cx="876300" cy="40491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sv-SE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6.1%</a:t>
                    </a:r>
                    <a:endParaRPr lang="sv-SE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47" name="TextBox 146"/>
                <p:cNvSpPr txBox="1"/>
                <p:nvPr/>
              </p:nvSpPr>
              <p:spPr>
                <a:xfrm>
                  <a:off x="8252524" y="801477"/>
                  <a:ext cx="736341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r>
                    <a:rPr lang="sv-SE" sz="11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l-GR" sz="11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sv-SE" sz="11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</a:t>
                  </a:r>
                  <a:endParaRPr lang="sv-SE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139" name="Group 138"/>
            <p:cNvGrpSpPr/>
            <p:nvPr/>
          </p:nvGrpSpPr>
          <p:grpSpPr>
            <a:xfrm>
              <a:off x="964266" y="3158782"/>
              <a:ext cx="4471630" cy="337808"/>
              <a:chOff x="4083399" y="2349334"/>
              <a:chExt cx="5232179" cy="457724"/>
            </a:xfrm>
          </p:grpSpPr>
          <p:sp>
            <p:nvSpPr>
              <p:cNvPr id="140" name="Right Triangle 139"/>
              <p:cNvSpPr/>
              <p:nvPr/>
            </p:nvSpPr>
            <p:spPr>
              <a:xfrm flipH="1">
                <a:off x="4083399" y="2349334"/>
                <a:ext cx="5062335" cy="380999"/>
              </a:xfrm>
              <a:prstGeom prst="rtTriangl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141" name="TextBox 140"/>
              <p:cNvSpPr txBox="1"/>
              <p:nvPr/>
            </p:nvSpPr>
            <p:spPr>
              <a:xfrm>
                <a:off x="7381160" y="2452581"/>
                <a:ext cx="1934418" cy="3544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1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nti-CD3/CD28 beads</a:t>
                </a:r>
                <a:endParaRPr lang="sv-SE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6208587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11668"/>
            <a:ext cx="89916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. </a:t>
            </a:r>
            <a:r>
              <a:rPr lang="sv-S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SF-1R inhibition restores T cell functions diminshed by T-cell released M-CSF.</a:t>
            </a:r>
            <a:endParaRPr lang="sv-S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sv-S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6200" y="418962"/>
            <a:ext cx="811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sv-S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2269709"/>
              </p:ext>
            </p:extLst>
          </p:nvPr>
        </p:nvGraphicFramePr>
        <p:xfrm>
          <a:off x="349250" y="600075"/>
          <a:ext cx="3198813" cy="2884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57" name="Prism 6" r:id="rId3" imgW="4214705" imgH="3799035" progId="Prism6.Document">
                  <p:embed/>
                </p:oleObj>
              </mc:Choice>
              <mc:Fallback>
                <p:oleObj name="Prism 6" r:id="rId3" imgW="4214705" imgH="3799035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9250" y="600075"/>
                        <a:ext cx="3198813" cy="28844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3720974" y="418962"/>
            <a:ext cx="811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6200" y="3505200"/>
            <a:ext cx="811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28" name="Group 27"/>
          <p:cNvGrpSpPr/>
          <p:nvPr/>
        </p:nvGrpSpPr>
        <p:grpSpPr>
          <a:xfrm>
            <a:off x="371513" y="3880002"/>
            <a:ext cx="4352887" cy="2530650"/>
            <a:chOff x="-1271006" y="4990486"/>
            <a:chExt cx="4352887" cy="2530650"/>
          </a:xfrm>
        </p:grpSpPr>
        <p:grpSp>
          <p:nvGrpSpPr>
            <p:cNvPr id="10" name="Group 9"/>
            <p:cNvGrpSpPr/>
            <p:nvPr/>
          </p:nvGrpSpPr>
          <p:grpSpPr>
            <a:xfrm>
              <a:off x="-1271006" y="5390596"/>
              <a:ext cx="2149564" cy="2099221"/>
              <a:chOff x="3599657" y="1180356"/>
              <a:chExt cx="2149564" cy="2099221"/>
            </a:xfrm>
          </p:grpSpPr>
          <p:pic>
            <p:nvPicPr>
              <p:cNvPr id="11" name="Picture 2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768803" y="1528465"/>
                <a:ext cx="1472591" cy="14478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12" name="Group 11"/>
              <p:cNvGrpSpPr/>
              <p:nvPr/>
            </p:nvGrpSpPr>
            <p:grpSpPr>
              <a:xfrm>
                <a:off x="3599657" y="1180356"/>
                <a:ext cx="2149564" cy="2099221"/>
                <a:chOff x="90100" y="2477793"/>
                <a:chExt cx="2149564" cy="2099221"/>
              </a:xfrm>
            </p:grpSpPr>
            <p:sp>
              <p:nvSpPr>
                <p:cNvPr id="13" name="TextBox 12"/>
                <p:cNvSpPr txBox="1"/>
                <p:nvPr/>
              </p:nvSpPr>
              <p:spPr>
                <a:xfrm>
                  <a:off x="745723" y="4269237"/>
                  <a:ext cx="115363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D73</a:t>
                  </a:r>
                  <a:endParaRPr lang="sv-SE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4" name="Group 13"/>
                <p:cNvGrpSpPr/>
                <p:nvPr/>
              </p:nvGrpSpPr>
              <p:grpSpPr>
                <a:xfrm>
                  <a:off x="90100" y="2477793"/>
                  <a:ext cx="2149564" cy="1800754"/>
                  <a:chOff x="90100" y="2477793"/>
                  <a:chExt cx="2149564" cy="1800754"/>
                </a:xfrm>
              </p:grpSpPr>
              <p:sp>
                <p:nvSpPr>
                  <p:cNvPr id="15" name="TextBox 14"/>
                  <p:cNvSpPr txBox="1"/>
                  <p:nvPr/>
                </p:nvSpPr>
                <p:spPr>
                  <a:xfrm rot="16200000">
                    <a:off x="-594461" y="3316987"/>
                    <a:ext cx="164612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sv-SE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ormalized to Mode</a:t>
                    </a:r>
                    <a:endParaRPr lang="sv-SE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" name="TextBox 15"/>
                  <p:cNvSpPr txBox="1"/>
                  <p:nvPr/>
                </p:nvSpPr>
                <p:spPr>
                  <a:xfrm>
                    <a:off x="1309300" y="2893172"/>
                    <a:ext cx="930364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sv-SE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yeloid</a:t>
                    </a:r>
                  </a:p>
                  <a:p>
                    <a:r>
                      <a:rPr lang="sv-SE" sz="12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FI: 7479</a:t>
                    </a:r>
                    <a:endParaRPr lang="sv-SE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" name="TextBox 16"/>
                  <p:cNvSpPr txBox="1"/>
                  <p:nvPr/>
                </p:nvSpPr>
                <p:spPr>
                  <a:xfrm>
                    <a:off x="397580" y="2477793"/>
                    <a:ext cx="1087979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sv-SE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ymphocytes</a:t>
                    </a:r>
                  </a:p>
                  <a:p>
                    <a:r>
                      <a:rPr lang="sv-SE" sz="12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FI: 181</a:t>
                    </a:r>
                    <a:endParaRPr lang="sv-SE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sp>
          <p:nvSpPr>
            <p:cNvPr id="18" name="TextBox 17"/>
            <p:cNvSpPr txBox="1"/>
            <p:nvPr/>
          </p:nvSpPr>
          <p:spPr>
            <a:xfrm>
              <a:off x="-304800" y="4990486"/>
              <a:ext cx="1981200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uman PBMC</a:t>
              </a:r>
              <a:endParaRPr lang="sv-S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sv-S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MLR day 6)</a:t>
              </a:r>
              <a:endParaRPr lang="sv-S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" name="Group 18"/>
            <p:cNvGrpSpPr/>
            <p:nvPr/>
          </p:nvGrpSpPr>
          <p:grpSpPr>
            <a:xfrm>
              <a:off x="700135" y="5390596"/>
              <a:ext cx="2381746" cy="2130540"/>
              <a:chOff x="2114053" y="1205265"/>
              <a:chExt cx="2381746" cy="2130540"/>
            </a:xfrm>
          </p:grpSpPr>
          <p:pic>
            <p:nvPicPr>
              <p:cNvPr id="20" name="Picture 93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252552" y="1565126"/>
                <a:ext cx="1490352" cy="146526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21" name="Group 20"/>
              <p:cNvGrpSpPr/>
              <p:nvPr/>
            </p:nvGrpSpPr>
            <p:grpSpPr>
              <a:xfrm>
                <a:off x="2114053" y="1205265"/>
                <a:ext cx="2381746" cy="2130540"/>
                <a:chOff x="90100" y="2470201"/>
                <a:chExt cx="2381746" cy="2130540"/>
              </a:xfrm>
            </p:grpSpPr>
            <p:sp>
              <p:nvSpPr>
                <p:cNvPr id="22" name="TextBox 21"/>
                <p:cNvSpPr txBox="1"/>
                <p:nvPr/>
              </p:nvSpPr>
              <p:spPr>
                <a:xfrm>
                  <a:off x="674735" y="4292964"/>
                  <a:ext cx="115363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sv-SE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D39</a:t>
                  </a:r>
                  <a:endParaRPr lang="sv-SE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23" name="Group 22"/>
                <p:cNvGrpSpPr/>
                <p:nvPr/>
              </p:nvGrpSpPr>
              <p:grpSpPr>
                <a:xfrm>
                  <a:off x="90100" y="2470201"/>
                  <a:ext cx="2381746" cy="1808346"/>
                  <a:chOff x="90100" y="2470201"/>
                  <a:chExt cx="2381746" cy="1808346"/>
                </a:xfrm>
              </p:grpSpPr>
              <p:sp>
                <p:nvSpPr>
                  <p:cNvPr id="24" name="TextBox 23"/>
                  <p:cNvSpPr txBox="1"/>
                  <p:nvPr/>
                </p:nvSpPr>
                <p:spPr>
                  <a:xfrm rot="16200000">
                    <a:off x="-594461" y="3316987"/>
                    <a:ext cx="164612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sv-SE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ormalized to Mode</a:t>
                    </a:r>
                    <a:endParaRPr lang="sv-SE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" name="TextBox 24"/>
                  <p:cNvSpPr txBox="1"/>
                  <p:nvPr/>
                </p:nvSpPr>
                <p:spPr>
                  <a:xfrm>
                    <a:off x="1309299" y="2844999"/>
                    <a:ext cx="1162547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sv-SE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yeloid</a:t>
                    </a:r>
                  </a:p>
                  <a:p>
                    <a:r>
                      <a:rPr lang="sv-SE" sz="12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FI: 10179</a:t>
                    </a:r>
                    <a:endParaRPr lang="sv-SE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" name="TextBox 25"/>
                  <p:cNvSpPr txBox="1"/>
                  <p:nvPr/>
                </p:nvSpPr>
                <p:spPr>
                  <a:xfrm>
                    <a:off x="369318" y="2470201"/>
                    <a:ext cx="1087979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sv-SE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ymphocytes</a:t>
                    </a:r>
                  </a:p>
                  <a:p>
                    <a:r>
                      <a:rPr lang="sv-SE" sz="12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FI: 230</a:t>
                    </a:r>
                    <a:endParaRPr lang="sv-SE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</p:grpSp>
      <p:sp>
        <p:nvSpPr>
          <p:cNvPr id="27" name="TextBox 26"/>
          <p:cNvSpPr txBox="1"/>
          <p:nvPr/>
        </p:nvSpPr>
        <p:spPr>
          <a:xfrm>
            <a:off x="4953000" y="3465821"/>
            <a:ext cx="811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20429739"/>
              </p:ext>
            </p:extLst>
          </p:nvPr>
        </p:nvGraphicFramePr>
        <p:xfrm>
          <a:off x="5257800" y="3505200"/>
          <a:ext cx="2413000" cy="3292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58" name="Prism 6" r:id="rId7" imgW="2532638" imgH="3455991" progId="Prism6.Document">
                  <p:embed/>
                </p:oleObj>
              </mc:Choice>
              <mc:Fallback>
                <p:oleObj name="Prism 6" r:id="rId7" imgW="2532638" imgH="345599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257800" y="3505200"/>
                        <a:ext cx="2413000" cy="3292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4" name="Group 33"/>
          <p:cNvGrpSpPr/>
          <p:nvPr/>
        </p:nvGrpSpPr>
        <p:grpSpPr>
          <a:xfrm>
            <a:off x="4109494" y="418962"/>
            <a:ext cx="2519906" cy="2982237"/>
            <a:chOff x="4109494" y="418962"/>
            <a:chExt cx="2519906" cy="2982237"/>
          </a:xfrm>
        </p:grpSpPr>
        <p:graphicFrame>
          <p:nvGraphicFramePr>
            <p:cNvPr id="29" name="Object 2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82532317"/>
                </p:ext>
              </p:extLst>
            </p:nvPr>
          </p:nvGraphicFramePr>
          <p:xfrm>
            <a:off x="4109494" y="418962"/>
            <a:ext cx="1965223" cy="28437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459" name="Prism 6" r:id="rId9" imgW="1977949" imgH="2861695" progId="Prism6.Document">
                    <p:embed/>
                  </p:oleObj>
                </mc:Choice>
                <mc:Fallback>
                  <p:oleObj name="Prism 6" r:id="rId9" imgW="1977949" imgH="2861695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4109494" y="418962"/>
                          <a:ext cx="1965223" cy="28437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1" name="TextBox 30"/>
            <p:cNvSpPr txBox="1"/>
            <p:nvPr/>
          </p:nvSpPr>
          <p:spPr>
            <a:xfrm>
              <a:off x="4876800" y="3124200"/>
              <a:ext cx="1752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-CSF (ng/ml)</a:t>
              </a:r>
              <a:endParaRPr lang="sv-S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3" name="Group 32"/>
          <p:cNvGrpSpPr/>
          <p:nvPr/>
        </p:nvGrpSpPr>
        <p:grpSpPr>
          <a:xfrm>
            <a:off x="5943600" y="423863"/>
            <a:ext cx="2060575" cy="2977336"/>
            <a:chOff x="5943600" y="423863"/>
            <a:chExt cx="2060575" cy="2977336"/>
          </a:xfrm>
        </p:grpSpPr>
        <p:graphicFrame>
          <p:nvGraphicFramePr>
            <p:cNvPr id="30" name="Object 2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76117047"/>
                </p:ext>
              </p:extLst>
            </p:nvPr>
          </p:nvGraphicFramePr>
          <p:xfrm>
            <a:off x="5943600" y="423863"/>
            <a:ext cx="2060575" cy="27051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460" name="Prism 6" r:id="rId11" imgW="2060018" imgH="2704752" progId="Prism6.Document">
                    <p:embed/>
                  </p:oleObj>
                </mc:Choice>
                <mc:Fallback>
                  <p:oleObj name="Prism 6" r:id="rId11" imgW="2060018" imgH="2704752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5943600" y="423863"/>
                          <a:ext cx="2060575" cy="27051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2" name="TextBox 31"/>
            <p:cNvSpPr txBox="1"/>
            <p:nvPr/>
          </p:nvSpPr>
          <p:spPr>
            <a:xfrm>
              <a:off x="6248400" y="3124200"/>
              <a:ext cx="1752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 cell supernatants (%)</a:t>
              </a:r>
              <a:endParaRPr lang="sv-S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5" name="Group 34"/>
          <p:cNvGrpSpPr/>
          <p:nvPr/>
        </p:nvGrpSpPr>
        <p:grpSpPr>
          <a:xfrm>
            <a:off x="7626163" y="678990"/>
            <a:ext cx="908237" cy="692610"/>
            <a:chOff x="7921323" y="358965"/>
            <a:chExt cx="908237" cy="692610"/>
          </a:xfrm>
        </p:grpSpPr>
        <p:grpSp>
          <p:nvGrpSpPr>
            <p:cNvPr id="36" name="Group 35"/>
            <p:cNvGrpSpPr/>
            <p:nvPr/>
          </p:nvGrpSpPr>
          <p:grpSpPr>
            <a:xfrm>
              <a:off x="7921323" y="358965"/>
              <a:ext cx="899149" cy="261610"/>
              <a:chOff x="8237171" y="610425"/>
              <a:chExt cx="899149" cy="261610"/>
            </a:xfrm>
          </p:grpSpPr>
          <p:sp>
            <p:nvSpPr>
              <p:cNvPr id="40" name="TextBox 39"/>
              <p:cNvSpPr txBox="1"/>
              <p:nvPr/>
            </p:nvSpPr>
            <p:spPr>
              <a:xfrm>
                <a:off x="8381891" y="610425"/>
                <a:ext cx="75442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MSO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41" name="Picture 546"/>
              <p:cNvPicPr>
                <a:picLocks noChangeAspect="1" noChangeArrowheads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237171" y="692696"/>
                <a:ext cx="216024" cy="9706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grpSp>
          <p:nvGrpSpPr>
            <p:cNvPr id="37" name="Group 36"/>
            <p:cNvGrpSpPr/>
            <p:nvPr/>
          </p:nvGrpSpPr>
          <p:grpSpPr>
            <a:xfrm>
              <a:off x="7950323" y="620688"/>
              <a:ext cx="879237" cy="430887"/>
              <a:chOff x="8263616" y="762825"/>
              <a:chExt cx="879237" cy="430887"/>
            </a:xfrm>
          </p:grpSpPr>
          <p:pic>
            <p:nvPicPr>
              <p:cNvPr id="38" name="Picture 547"/>
              <p:cNvPicPr>
                <a:picLocks noChangeAspect="1" noChangeArrowheads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263616" y="836712"/>
                <a:ext cx="196816" cy="108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9" name="TextBox 38"/>
              <p:cNvSpPr txBox="1"/>
              <p:nvPr/>
            </p:nvSpPr>
            <p:spPr>
              <a:xfrm>
                <a:off x="8388424" y="762825"/>
                <a:ext cx="754429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LZ945 (1 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)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0421447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0" y="11668"/>
            <a:ext cx="8991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6. </a:t>
            </a:r>
            <a:r>
              <a:rPr lang="sv-S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orrelation of </a:t>
            </a:r>
            <a:r>
              <a:rPr lang="sv-SE" sz="1600" i="1" smtClean="0">
                <a:latin typeface="Arial" panose="020B0604020202020204" pitchFamily="34" charset="0"/>
                <a:cs typeface="Arial" panose="020B0604020202020204" pitchFamily="34" charset="0"/>
              </a:rPr>
              <a:t>CD73</a:t>
            </a:r>
            <a:r>
              <a:rPr lang="sv-SE" sz="1600" smtClean="0">
                <a:latin typeface="Arial" panose="020B0604020202020204" pitchFamily="34" charset="0"/>
                <a:cs typeface="Arial" panose="020B0604020202020204" pitchFamily="34" charset="0"/>
              </a:rPr>
              <a:t> gene to </a:t>
            </a:r>
            <a:r>
              <a:rPr lang="sv-S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yeloid cells and survival in human neuroblastoma. </a:t>
            </a:r>
            <a:endParaRPr lang="sv-S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0" y="1350966"/>
            <a:ext cx="16306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TH-</a:t>
            </a:r>
            <a:r>
              <a:rPr lang="sv-SE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YCN</a:t>
            </a:r>
            <a:r>
              <a:rPr lang="sv-S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sv-SE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endParaRPr lang="sv-S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967676" y="867303"/>
            <a:ext cx="2156524" cy="2157770"/>
            <a:chOff x="5555044" y="1341446"/>
            <a:chExt cx="2156524" cy="2157770"/>
          </a:xfrm>
        </p:grpSpPr>
        <p:graphicFrame>
          <p:nvGraphicFramePr>
            <p:cNvPr id="19" name="Object 1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499234"/>
                </p:ext>
              </p:extLst>
            </p:nvPr>
          </p:nvGraphicFramePr>
          <p:xfrm>
            <a:off x="5555044" y="1441816"/>
            <a:ext cx="2156524" cy="2057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753" name="Prism 6" r:id="rId3" imgW="2811603" imgH="2683514" progId="Prism6.Document">
                    <p:embed/>
                  </p:oleObj>
                </mc:Choice>
                <mc:Fallback>
                  <p:oleObj name="Prism 6" r:id="rId3" imgW="2811603" imgH="2683514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5555044" y="1441816"/>
                          <a:ext cx="2156524" cy="2057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3" name="TextBox 22"/>
            <p:cNvSpPr txBox="1"/>
            <p:nvPr/>
          </p:nvSpPr>
          <p:spPr>
            <a:xfrm>
              <a:off x="6057964" y="1341446"/>
              <a:ext cx="11125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yeloid cells</a:t>
              </a:r>
              <a:endParaRPr lang="sv-S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430885" y="3070265"/>
            <a:ext cx="1545689" cy="1632364"/>
            <a:chOff x="5486400" y="3197756"/>
            <a:chExt cx="1515233" cy="1600200"/>
          </a:xfrm>
        </p:grpSpPr>
        <p:graphicFrame>
          <p:nvGraphicFramePr>
            <p:cNvPr id="13" name="Object 1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42155366"/>
                </p:ext>
              </p:extLst>
            </p:nvPr>
          </p:nvGraphicFramePr>
          <p:xfrm>
            <a:off x="5486400" y="3352800"/>
            <a:ext cx="1515233" cy="144515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754" name="Prism 6" r:id="rId5" imgW="2811603" imgH="2683514" progId="Prism6.Document">
                    <p:embed/>
                  </p:oleObj>
                </mc:Choice>
                <mc:Fallback>
                  <p:oleObj name="Prism 6" r:id="rId5" imgW="2811603" imgH="2683514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5486400" y="3352800"/>
                          <a:ext cx="1515233" cy="144515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4" name="TextBox 23"/>
            <p:cNvSpPr txBox="1"/>
            <p:nvPr/>
          </p:nvSpPr>
          <p:spPr>
            <a:xfrm>
              <a:off x="5791200" y="3197756"/>
              <a:ext cx="11125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4 T cells</a:t>
              </a:r>
              <a:endParaRPr lang="sv-S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1798358" y="3070112"/>
            <a:ext cx="1544339" cy="1647909"/>
            <a:chOff x="6858000" y="3048000"/>
            <a:chExt cx="1513910" cy="1615439"/>
          </a:xfrm>
        </p:grpSpPr>
        <p:graphicFrame>
          <p:nvGraphicFramePr>
            <p:cNvPr id="15" name="Object 1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71364226"/>
                </p:ext>
              </p:extLst>
            </p:nvPr>
          </p:nvGraphicFramePr>
          <p:xfrm>
            <a:off x="6858000" y="3215639"/>
            <a:ext cx="1513910" cy="1447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755" name="Prism 6" r:id="rId7" imgW="2811603" imgH="2683514" progId="Prism6.Document">
                    <p:embed/>
                  </p:oleObj>
                </mc:Choice>
                <mc:Fallback>
                  <p:oleObj name="Prism 6" r:id="rId7" imgW="2811603" imgH="2683514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6858000" y="3215639"/>
                          <a:ext cx="1513910" cy="14478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5" name="TextBox 24"/>
            <p:cNvSpPr txBox="1"/>
            <p:nvPr/>
          </p:nvSpPr>
          <p:spPr>
            <a:xfrm>
              <a:off x="7162800" y="3048000"/>
              <a:ext cx="11125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8 T cells</a:t>
              </a:r>
              <a:endParaRPr lang="sv-S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" name="Group 27"/>
          <p:cNvGrpSpPr/>
          <p:nvPr/>
        </p:nvGrpSpPr>
        <p:grpSpPr>
          <a:xfrm>
            <a:off x="426691" y="4670248"/>
            <a:ext cx="1551083" cy="1654352"/>
            <a:chOff x="5567226" y="4648200"/>
            <a:chExt cx="1520521" cy="1621754"/>
          </a:xfrm>
        </p:grpSpPr>
        <p:graphicFrame>
          <p:nvGraphicFramePr>
            <p:cNvPr id="16" name="Object 1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56742445"/>
                </p:ext>
              </p:extLst>
            </p:nvPr>
          </p:nvGraphicFramePr>
          <p:xfrm>
            <a:off x="5567226" y="4824798"/>
            <a:ext cx="1520521" cy="144515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756" name="Prism 6" r:id="rId9" imgW="2820602" imgH="2683514" progId="Prism6.Document">
                    <p:embed/>
                  </p:oleObj>
                </mc:Choice>
                <mc:Fallback>
                  <p:oleObj name="Prism 6" r:id="rId9" imgW="2820602" imgH="2683514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5567226" y="4824798"/>
                          <a:ext cx="1520521" cy="144515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6" name="TextBox 25"/>
            <p:cNvSpPr txBox="1"/>
            <p:nvPr/>
          </p:nvSpPr>
          <p:spPr>
            <a:xfrm>
              <a:off x="6050280" y="4648200"/>
              <a:ext cx="6553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 cells</a:t>
              </a:r>
              <a:endParaRPr lang="sv-S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1807112" y="4670452"/>
            <a:ext cx="1545688" cy="1633729"/>
            <a:chOff x="6961444" y="4648200"/>
            <a:chExt cx="1515232" cy="1601538"/>
          </a:xfrm>
        </p:grpSpPr>
        <p:graphicFrame>
          <p:nvGraphicFramePr>
            <p:cNvPr id="2" name="Object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22251893"/>
                </p:ext>
              </p:extLst>
            </p:nvPr>
          </p:nvGraphicFramePr>
          <p:xfrm>
            <a:off x="6961444" y="4801938"/>
            <a:ext cx="1515232" cy="1447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757" name="Prism 6" r:id="rId11" imgW="2811603" imgH="2683514" progId="Prism6.Document">
                    <p:embed/>
                  </p:oleObj>
                </mc:Choice>
                <mc:Fallback>
                  <p:oleObj name="Prism 6" r:id="rId11" imgW="2811603" imgH="2683514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6961444" y="4801938"/>
                          <a:ext cx="1515232" cy="14478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7" name="TextBox 26"/>
            <p:cNvSpPr txBox="1"/>
            <p:nvPr/>
          </p:nvSpPr>
          <p:spPr>
            <a:xfrm>
              <a:off x="7257476" y="4648200"/>
              <a:ext cx="11125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umor cells</a:t>
              </a:r>
              <a:endParaRPr lang="sv-S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0" name="Picture 7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2533" y="3471227"/>
            <a:ext cx="3464667" cy="2428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1" name="TextBox 40"/>
          <p:cNvSpPr txBox="1"/>
          <p:nvPr/>
        </p:nvSpPr>
        <p:spPr>
          <a:xfrm>
            <a:off x="76200" y="838200"/>
            <a:ext cx="811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sv-S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926733" y="3276600"/>
            <a:ext cx="811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sv-S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048000" y="838200"/>
            <a:ext cx="811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sv-S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2526605"/>
              </p:ext>
            </p:extLst>
          </p:nvPr>
        </p:nvGraphicFramePr>
        <p:xfrm>
          <a:off x="3363276" y="1027660"/>
          <a:ext cx="1912263" cy="19051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758" name="Prism 6" r:id="rId14" imgW="2427532" imgH="2420022" progId="Prism6.Document">
                  <p:embed/>
                </p:oleObj>
              </mc:Choice>
              <mc:Fallback>
                <p:oleObj name="Prism 6" r:id="rId14" imgW="2427532" imgH="2420022" progId="Prism6.Document">
                  <p:embed/>
                  <p:pic>
                    <p:nvPicPr>
                      <p:cNvPr id="0" name="Object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63276" y="1027660"/>
                        <a:ext cx="1912263" cy="190510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72379669"/>
              </p:ext>
            </p:extLst>
          </p:nvPr>
        </p:nvGraphicFramePr>
        <p:xfrm>
          <a:off x="5170416" y="1027660"/>
          <a:ext cx="1912262" cy="19051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759" name="Prism 6" r:id="rId16" imgW="2427532" imgH="2420022" progId="Prism6.Document">
                  <p:embed/>
                </p:oleObj>
              </mc:Choice>
              <mc:Fallback>
                <p:oleObj name="Prism 6" r:id="rId16" imgW="2427532" imgH="2420022" progId="Prism6.Document">
                  <p:embed/>
                  <p:pic>
                    <p:nvPicPr>
                      <p:cNvPr id="0" name="Object 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170416" y="1027660"/>
                        <a:ext cx="1912262" cy="190510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4591646"/>
              </p:ext>
            </p:extLst>
          </p:nvPr>
        </p:nvGraphicFramePr>
        <p:xfrm>
          <a:off x="6959529" y="1027660"/>
          <a:ext cx="1912262" cy="19051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760" name="Prism 6" r:id="rId18" imgW="2427532" imgH="2420022" progId="Prism6.Document">
                  <p:embed/>
                </p:oleObj>
              </mc:Choice>
              <mc:Fallback>
                <p:oleObj name="Prism 6" r:id="rId18" imgW="2427532" imgH="2420022" progId="Prism6.Document">
                  <p:embed/>
                  <p:pic>
                    <p:nvPicPr>
                      <p:cNvPr id="0" name="Object 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959529" y="1027660"/>
                        <a:ext cx="1912262" cy="190510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256653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92</TotalTime>
  <Words>337</Words>
  <Application>Microsoft Office PowerPoint</Application>
  <PresentationFormat>On-screen Show (4:3)</PresentationFormat>
  <Paragraphs>145</Paragraphs>
  <Slides>6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8" baseType="lpstr">
      <vt:lpstr>Office Theme</vt:lpstr>
      <vt:lpstr>Prism 6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meng Mao</dc:creator>
  <cp:lastModifiedBy>K6-NINEIS-M</cp:lastModifiedBy>
  <cp:revision>92</cp:revision>
  <cp:lastPrinted>2016-06-07T07:23:46Z</cp:lastPrinted>
  <dcterms:created xsi:type="dcterms:W3CDTF">2006-08-16T00:00:00Z</dcterms:created>
  <dcterms:modified xsi:type="dcterms:W3CDTF">2016-07-10T11:42:51Z</dcterms:modified>
</cp:coreProperties>
</file>